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708" r:id="rId2"/>
    <p:sldId id="703" r:id="rId3"/>
    <p:sldId id="726" r:id="rId4"/>
    <p:sldId id="725" r:id="rId5"/>
    <p:sldId id="727" r:id="rId6"/>
    <p:sldId id="728" r:id="rId7"/>
    <p:sldId id="722" r:id="rId8"/>
  </p:sldIdLst>
  <p:sldSz cx="7772400" cy="12192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B98524BE-01FE-4B90-8DA5-97A0C82B7E66}">
          <p14:sldIdLst>
            <p14:sldId id="708"/>
            <p14:sldId id="703"/>
            <p14:sldId id="726"/>
            <p14:sldId id="725"/>
            <p14:sldId id="727"/>
            <p14:sldId id="728"/>
            <p14:sldId id="72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4560" userDrawn="1">
          <p15:clr>
            <a:srgbClr val="A4A3A4"/>
          </p15:clr>
        </p15:guide>
        <p15:guide id="2" pos="283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A61DA60-3E1B-05A8-DA51-C73F22A3E033}" name="Shashi Jain" initials="SJ" userId="1fe368a082370b0f" providerId="Windows Live"/>
  <p188:author id="{1322F19E-6AE7-98F8-1EA6-14405AAB0501}" name="Bota, Daniela" initials="DB" userId="S::dbota@hs.uci.edu::729b5e34-3bd0-4b4f-8cdf-20fd77d82c1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C7A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57" autoAdjust="0"/>
  </p:normalViewPr>
  <p:slideViewPr>
    <p:cSldViewPr snapToGrid="0">
      <p:cViewPr varScale="1">
        <p:scale>
          <a:sx n="65" d="100"/>
          <a:sy n="65" d="100"/>
        </p:scale>
        <p:origin x="3252" y="72"/>
      </p:cViewPr>
      <p:guideLst>
        <p:guide orient="horz" pos="4560"/>
        <p:guide pos="283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Bota%20R01\Experiments\Experiment%2030%20Proteosome%20activity%20Chris%20data\03.31.2019_Proteasome_ExpB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Bota%20R01\Experiments\Experiment%2030%20Proteosome%20activity%20Chris%20data\03.31.2019_Proteasome_ExpB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Bota%20R01\Experiments\Experiment%2030%20Proteosome%20activity%20Chris%20data\03.31.2019_Proteasome_ExpB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0" i="0" baseline="0">
                <a:solidFill>
                  <a:sysClr val="windowText" lastClr="000000"/>
                </a:solidFill>
                <a:effectLst/>
              </a:rPr>
              <a:t>BT395 Proteasome Inhibition</a:t>
            </a:r>
            <a:endParaRPr lang="en-US">
              <a:solidFill>
                <a:sysClr val="windowText" lastClr="000000"/>
              </a:solidFill>
              <a:effectLst/>
            </a:endParaRPr>
          </a:p>
        </c:rich>
      </c:tx>
      <c:layout>
        <c:manualLayout>
          <c:xMode val="edge"/>
          <c:yMode val="edge"/>
          <c:x val="0.12198618023806769"/>
          <c:y val="5.08670520231213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3236725510847611"/>
          <c:y val="0.17595760303719776"/>
          <c:w val="0.61854688063533991"/>
          <c:h val="0.71445961653073253"/>
        </c:manualLayout>
      </c:layout>
      <c:barChart>
        <c:barDir val="col"/>
        <c:grouping val="clustered"/>
        <c:varyColors val="0"/>
        <c:ser>
          <c:idx val="6"/>
          <c:order val="6"/>
          <c:tx>
            <c:strRef>
              <c:f>'CT-L'!$BT$73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rgbClr val="FFFFFF"/>
            </a:solidFill>
            <a:ln cap="sq">
              <a:solidFill>
                <a:schemeClr val="tx1"/>
              </a:solidFill>
              <a:round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T-L'!$BB$34:$BD$34</c:f>
                <c:numCache>
                  <c:formatCode>General</c:formatCode>
                  <c:ptCount val="3"/>
                  <c:pt idx="0">
                    <c:v>8.6606862173205261</c:v>
                  </c:pt>
                  <c:pt idx="1">
                    <c:v>3.7584291605444187</c:v>
                  </c:pt>
                  <c:pt idx="2">
                    <c:v>2.9825475793688816</c:v>
                  </c:pt>
                </c:numCache>
              </c:numRef>
            </c:plus>
            <c:minus>
              <c:numRef>
                <c:f>'CT-L'!$BB$34:$BD$34</c:f>
                <c:numCache>
                  <c:formatCode>General</c:formatCode>
                  <c:ptCount val="3"/>
                  <c:pt idx="0">
                    <c:v>8.6606862173205261</c:v>
                  </c:pt>
                  <c:pt idx="1">
                    <c:v>3.7584291605444187</c:v>
                  </c:pt>
                  <c:pt idx="2">
                    <c:v>2.9825475793688816</c:v>
                  </c:pt>
                </c:numCache>
              </c:numRef>
            </c:minus>
          </c:errBars>
          <c:cat>
            <c:strRef>
              <c:f>'CT-L'!$AL$32:$AN$32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BB$33:$BD$33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71-41B1-97AA-C079946E3E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5"/>
        <c:overlap val="20"/>
        <c:axId val="90515824"/>
        <c:axId val="96838320"/>
      </c:barChart>
      <c:barChart>
        <c:barDir val="col"/>
        <c:grouping val="clustered"/>
        <c:varyColors val="0"/>
        <c:ser>
          <c:idx val="1"/>
          <c:order val="2"/>
          <c:tx>
            <c:strRef>
              <c:f>'CT-L'!$BT$76</c:f>
              <c:strCache>
                <c:ptCount val="1"/>
                <c:pt idx="0">
                  <c:v>4 Hrs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0.14204404236890306</c:v>
                </c:pt>
                <c:pt idx="1">
                  <c:v>2.3741786631029473</c:v>
                </c:pt>
                <c:pt idx="2">
                  <c:v>3.570270175623397</c:v>
                </c:pt>
              </c:numLit>
            </c:plus>
            <c:minus>
              <c:numLit>
                <c:formatCode>General</c:formatCode>
                <c:ptCount val="3"/>
                <c:pt idx="0">
                  <c:v>0.14204404236890306</c:v>
                </c:pt>
                <c:pt idx="1">
                  <c:v>2.3741786631029473</c:v>
                </c:pt>
                <c:pt idx="2">
                  <c:v>3.570270175623397</c:v>
                </c:pt>
              </c:numLit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Lit>
              <c:formatCode>General</c:formatCode>
              <c:ptCount val="3"/>
              <c:pt idx="0">
                <c:v>60.604070912672348</c:v>
              </c:pt>
              <c:pt idx="1">
                <c:v>51.65702261967386</c:v>
              </c:pt>
              <c:pt idx="2">
                <c:v>52.40032546786005</c:v>
              </c:pt>
            </c:numLit>
          </c:val>
          <c:extLst>
            <c:ext xmlns:c16="http://schemas.microsoft.com/office/drawing/2014/chart" uri="{C3380CC4-5D6E-409C-BE32-E72D297353CC}">
              <c16:uniqueId val="{00000001-C071-41B1-97AA-C079946E3E5E}"/>
            </c:ext>
          </c:extLst>
        </c:ser>
        <c:ser>
          <c:idx val="0"/>
          <c:order val="3"/>
          <c:tx>
            <c:strRef>
              <c:f>'CT-L'!$BT$75</c:f>
              <c:strCache>
                <c:ptCount val="1"/>
                <c:pt idx="0">
                  <c:v>6 Hrs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T-L'!$BE$30:$BG$30</c:f>
                <c:numCache>
                  <c:formatCode>General</c:formatCode>
                  <c:ptCount val="3"/>
                  <c:pt idx="0">
                    <c:v>2.9995168064386579</c:v>
                  </c:pt>
                  <c:pt idx="1">
                    <c:v>3.8671290323905789</c:v>
                  </c:pt>
                  <c:pt idx="2">
                    <c:v>1.3106656993872037</c:v>
                  </c:pt>
                </c:numCache>
              </c:numRef>
            </c:plus>
            <c:minus>
              <c:numRef>
                <c:f>'CT-L'!$BE$30:$BG$30</c:f>
                <c:numCache>
                  <c:formatCode>General</c:formatCode>
                  <c:ptCount val="3"/>
                  <c:pt idx="0">
                    <c:v>2.9995168064386579</c:v>
                  </c:pt>
                  <c:pt idx="1">
                    <c:v>3.8671290323905789</c:v>
                  </c:pt>
                  <c:pt idx="2">
                    <c:v>1.3106656993872037</c:v>
                  </c:pt>
                </c:numCache>
              </c:numRef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AV$29:$AX$29</c:f>
              <c:numCache>
                <c:formatCode>General</c:formatCode>
                <c:ptCount val="3"/>
                <c:pt idx="0">
                  <c:v>163.64574376612211</c:v>
                </c:pt>
                <c:pt idx="1">
                  <c:v>202.46781115879827</c:v>
                </c:pt>
                <c:pt idx="2">
                  <c:v>208.647140864714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71-41B1-97AA-C079946E3E5E}"/>
            </c:ext>
          </c:extLst>
        </c:ser>
        <c:ser>
          <c:idx val="3"/>
          <c:order val="4"/>
          <c:tx>
            <c:strRef>
              <c:f>'CT-L'!$BT$74</c:f>
              <c:strCache>
                <c:ptCount val="1"/>
                <c:pt idx="0">
                  <c:v>8 Hrs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T-L'!$BU$30:$BW$30</c:f>
                <c:numCache>
                  <c:formatCode>General</c:formatCode>
                  <c:ptCount val="3"/>
                  <c:pt idx="0">
                    <c:v>3.6114727899513297</c:v>
                  </c:pt>
                  <c:pt idx="1">
                    <c:v>6.5993666586617081</c:v>
                  </c:pt>
                  <c:pt idx="2">
                    <c:v>11.313201975987235</c:v>
                  </c:pt>
                </c:numCache>
              </c:numRef>
            </c:plus>
            <c:minus>
              <c:numRef>
                <c:f>'CT-L'!$BU$30:$BW$30</c:f>
                <c:numCache>
                  <c:formatCode>General</c:formatCode>
                  <c:ptCount val="3"/>
                  <c:pt idx="0">
                    <c:v>3.6114727899513297</c:v>
                  </c:pt>
                  <c:pt idx="1">
                    <c:v>6.5993666586617081</c:v>
                  </c:pt>
                  <c:pt idx="2">
                    <c:v>11.313201975987235</c:v>
                  </c:pt>
                </c:numCache>
              </c:numRef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BL$29:$BN$29</c:f>
              <c:numCache>
                <c:formatCode>General</c:formatCode>
                <c:ptCount val="3"/>
                <c:pt idx="0">
                  <c:v>120.63628546861565</c:v>
                </c:pt>
                <c:pt idx="1">
                  <c:v>143.77682403433477</c:v>
                </c:pt>
                <c:pt idx="2">
                  <c:v>113.7726638772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071-41B1-97AA-C079946E3E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0"/>
        <c:overlap val="-50"/>
        <c:axId val="38906032"/>
        <c:axId val="89684432"/>
        <c:extLst>
          <c:ext xmlns:c15="http://schemas.microsoft.com/office/drawing/2012/chart" uri="{02D57815-91ED-43cb-92C2-25804820EDAC}">
            <c15:filteredBarSeries>
              <c15:ser>
                <c:idx val="5"/>
                <c:order val="0"/>
                <c:tx>
                  <c:strRef>
                    <c:extLst>
                      <c:ext uri="{02D57815-91ED-43cb-92C2-25804820EDAC}">
                        <c15:formulaRef>
                          <c15:sqref>'CT-L'!$BT$78</c15:sqref>
                        </c15:formulaRef>
                      </c:ext>
                    </c:extLst>
                    <c:strCache>
                      <c:ptCount val="1"/>
                      <c:pt idx="0">
                        <c:v>1 Hrs + 10mM NAC</c:v>
                      </c:pt>
                    </c:strCache>
                  </c:strRef>
                </c:tx>
                <c:spPr>
                  <a:solidFill>
                    <a:schemeClr val="bg2">
                      <a:lumMod val="75000"/>
                    </a:schemeClr>
                  </a:solidFill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CT-L'!$Z$30:$AB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5.0189025924515995</c:v>
                        </c:pt>
                        <c:pt idx="1">
                          <c:v>9.7779656661528751</c:v>
                        </c:pt>
                        <c:pt idx="2">
                          <c:v>12.317179545956149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CT-L'!$Z$30:$AB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5.0189025924515995</c:v>
                        </c:pt>
                        <c:pt idx="1">
                          <c:v>9.7779656661528751</c:v>
                        </c:pt>
                        <c:pt idx="2">
                          <c:v>12.317179545956149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CT-L'!$Z$19:$AB$19</c15:sqref>
                        </c15:formulaRef>
                      </c:ext>
                    </c:extLst>
                    <c:strCache>
                      <c:ptCount val="3"/>
                      <c:pt idx="0">
                        <c:v>CT-L</c:v>
                      </c:pt>
                      <c:pt idx="1">
                        <c:v>T-L</c:v>
                      </c:pt>
                      <c:pt idx="2">
                        <c:v>C-L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CT-L'!$Q$29:$S$29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85.338345864661648</c:v>
                      </c:pt>
                      <c:pt idx="1">
                        <c:v>81.549439347604491</c:v>
                      </c:pt>
                      <c:pt idx="2">
                        <c:v>73.100120627261759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4-C071-41B1-97AA-C079946E3E5E}"/>
                  </c:ext>
                </c:extLst>
              </c15:ser>
            </c15:filteredBarSeries>
            <c15:filteredBarSeries>
              <c15:ser>
                <c:idx val="2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BT$77</c15:sqref>
                        </c15:formulaRef>
                      </c:ext>
                    </c:extLst>
                    <c:strCache>
                      <c:ptCount val="1"/>
                      <c:pt idx="0">
                        <c:v>1 Hrs</c:v>
                      </c:pt>
                    </c:strCache>
                  </c:strRef>
                </c:tx>
                <c:spPr>
                  <a:solidFill>
                    <a:schemeClr val="tx2">
                      <a:lumMod val="20000"/>
                      <a:lumOff val="80000"/>
                    </a:schemeClr>
                  </a:solidFill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CT-L'!$AO$30:$AQ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8.0309912523252471</c:v>
                        </c:pt>
                        <c:pt idx="1">
                          <c:v>4.8852156385545973</c:v>
                        </c:pt>
                        <c:pt idx="2">
                          <c:v>5.2990575990178073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CT-L'!$AO$30:$AQ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8.0309912523252471</c:v>
                        </c:pt>
                        <c:pt idx="1">
                          <c:v>4.8852156385545973</c:v>
                        </c:pt>
                        <c:pt idx="2">
                          <c:v>5.2990575990178073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Z$19:$AB$19</c15:sqref>
                        </c15:formulaRef>
                      </c:ext>
                    </c:extLst>
                    <c:strCache>
                      <c:ptCount val="3"/>
                      <c:pt idx="0">
                        <c:v>CT-L</c:v>
                      </c:pt>
                      <c:pt idx="1">
                        <c:v>T-L</c:v>
                      </c:pt>
                      <c:pt idx="2">
                        <c:v>C-L</c:v>
                      </c:pt>
                    </c:strCache>
                  </c:strRef>
                </c:cat>
                <c:val>
                  <c:numLit>
                    <c:formatCode>General</c:formatCode>
                    <c:ptCount val="3"/>
                    <c:pt idx="0">
                      <c:v>116.53315824031516</c:v>
                    </c:pt>
                    <c:pt idx="1">
                      <c:v>76.380852183061549</c:v>
                    </c:pt>
                    <c:pt idx="2">
                      <c:v>101.05777054515866</c:v>
                    </c:pt>
                  </c:numLit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C071-41B1-97AA-C079946E3E5E}"/>
                  </c:ext>
                </c:extLst>
              </c15:ser>
            </c15:filteredBarSeries>
            <c15:filteredBarSeries>
              <c15:ser>
                <c:idx val="4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BT$106</c15:sqref>
                        </c15:formulaRef>
                      </c:ext>
                    </c:extLst>
                    <c:strCache>
                      <c:ptCount val="1"/>
                      <c:pt idx="0">
                        <c:v>8 Hrs 10nM BTZ</c:v>
                      </c:pt>
                    </c:strCache>
                  </c:strRef>
                </c:tx>
                <c:spPr>
                  <a:solidFill>
                    <a:schemeClr val="bg1">
                      <a:lumMod val="50000"/>
                    </a:schemeClr>
                  </a:solidFill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CT-L'!$BL$34:$BN$34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5.9771799468991418</c:v>
                        </c:pt>
                        <c:pt idx="1">
                          <c:v>3.2402722898157719</c:v>
                        </c:pt>
                        <c:pt idx="2">
                          <c:v>4.4690292803381082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CT-L'!$BL$34:$BN$34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5.9771799468991418</c:v>
                        </c:pt>
                        <c:pt idx="1">
                          <c:v>3.2402722898157719</c:v>
                        </c:pt>
                        <c:pt idx="2">
                          <c:v>4.4690292803381082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Z$19:$AB$19</c15:sqref>
                        </c15:formulaRef>
                      </c:ext>
                    </c:extLst>
                    <c:strCache>
                      <c:ptCount val="3"/>
                      <c:pt idx="0">
                        <c:v>CT-L</c:v>
                      </c:pt>
                      <c:pt idx="1">
                        <c:v>T-L</c:v>
                      </c:pt>
                      <c:pt idx="2">
                        <c:v>C-L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BL$33:$BN$33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77.489251934651762</c:v>
                      </c:pt>
                      <c:pt idx="1">
                        <c:v>73.927038626609431</c:v>
                      </c:pt>
                      <c:pt idx="2">
                        <c:v>65.620641562064165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C071-41B1-97AA-C079946E3E5E}"/>
                  </c:ext>
                </c:extLst>
              </c15:ser>
            </c15:filteredBarSeries>
          </c:ext>
        </c:extLst>
      </c:barChart>
      <c:valAx>
        <c:axId val="96838320"/>
        <c:scaling>
          <c:orientation val="minMax"/>
          <c:max val="22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% Proteasome activity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90515824"/>
        <c:crosses val="autoZero"/>
        <c:crossBetween val="between"/>
      </c:valAx>
      <c:catAx>
        <c:axId val="90515824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dirty="0"/>
                  <a:t>CT-L                T-L               C-L</a:t>
                </a:r>
              </a:p>
            </c:rich>
          </c:tx>
          <c:layout>
            <c:manualLayout>
              <c:xMode val="edge"/>
              <c:yMode val="edge"/>
              <c:x val="0.19044905511610402"/>
              <c:y val="0.8987806596128671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6838320"/>
        <c:crosses val="autoZero"/>
        <c:auto val="1"/>
        <c:lblAlgn val="ctr"/>
        <c:lblOffset val="100"/>
        <c:noMultiLvlLbl val="0"/>
      </c:catAx>
      <c:valAx>
        <c:axId val="89684432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38906032"/>
        <c:crosses val="max"/>
        <c:crossBetween val="between"/>
      </c:valAx>
      <c:catAx>
        <c:axId val="389060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9684432"/>
        <c:crosses val="autoZero"/>
        <c:auto val="1"/>
        <c:lblAlgn val="ctr"/>
        <c:lblOffset val="100"/>
        <c:noMultiLvlLbl val="0"/>
      </c:catAx>
      <c:spPr>
        <a:pattFill prst="pct5">
          <a:fgClr>
            <a:schemeClr val="bg2"/>
          </a:fgClr>
          <a:bgClr>
            <a:schemeClr val="bg1"/>
          </a:bgClr>
        </a:pattFill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75698128113603258"/>
          <c:y val="0.1816151412079644"/>
          <c:w val="0.17008716191955126"/>
          <c:h val="0.7130990678331649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0" i="0" baseline="0">
                <a:solidFill>
                  <a:sysClr val="windowText" lastClr="000000"/>
                </a:solidFill>
                <a:effectLst/>
              </a:rPr>
              <a:t>BT397 Proteasome Inhibition</a:t>
            </a:r>
            <a:endParaRPr lang="en-US">
              <a:solidFill>
                <a:sysClr val="windowText" lastClr="000000"/>
              </a:solidFill>
              <a:effectLst/>
            </a:endParaRPr>
          </a:p>
        </c:rich>
      </c:tx>
      <c:layout>
        <c:manualLayout>
          <c:xMode val="edge"/>
          <c:yMode val="edge"/>
          <c:x val="0.12198618023806769"/>
          <c:y val="5.08670520231213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3236722867448047"/>
          <c:y val="0.17497264338565852"/>
          <c:w val="0.66703179122765155"/>
          <c:h val="0.71605798881898663"/>
        </c:manualLayout>
      </c:layout>
      <c:barChart>
        <c:barDir val="col"/>
        <c:grouping val="clustered"/>
        <c:varyColors val="0"/>
        <c:ser>
          <c:idx val="6"/>
          <c:order val="6"/>
          <c:tx>
            <c:strRef>
              <c:f>'CT-L'!$BT$73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rgbClr val="FFFFFF"/>
            </a:solidFill>
            <a:ln cap="sq">
              <a:solidFill>
                <a:schemeClr val="tx1"/>
              </a:solidFill>
              <a:round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T-L'!$BB$34:$BD$34</c:f>
                <c:numCache>
                  <c:formatCode>General</c:formatCode>
                  <c:ptCount val="3"/>
                  <c:pt idx="0">
                    <c:v>8.6606862173205261</c:v>
                  </c:pt>
                  <c:pt idx="1">
                    <c:v>3.7584291605444187</c:v>
                  </c:pt>
                  <c:pt idx="2">
                    <c:v>2.9825475793688816</c:v>
                  </c:pt>
                </c:numCache>
              </c:numRef>
            </c:plus>
            <c:minus>
              <c:numRef>
                <c:f>'CT-L'!$BB$34:$BD$34</c:f>
                <c:numCache>
                  <c:formatCode>General</c:formatCode>
                  <c:ptCount val="3"/>
                  <c:pt idx="0">
                    <c:v>8.6606862173205261</c:v>
                  </c:pt>
                  <c:pt idx="1">
                    <c:v>3.7584291605444187</c:v>
                  </c:pt>
                  <c:pt idx="2">
                    <c:v>2.9825475793688816</c:v>
                  </c:pt>
                </c:numCache>
              </c:numRef>
            </c:minus>
          </c:errBars>
          <c:cat>
            <c:strRef>
              <c:f>'CT-L'!$AL$32:$AN$32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BB$33:$BD$33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0E-45F9-A3D1-625B9FF8AC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5"/>
        <c:overlap val="20"/>
        <c:axId val="90515824"/>
        <c:axId val="96838320"/>
      </c:barChart>
      <c:barChart>
        <c:barDir val="col"/>
        <c:grouping val="clustered"/>
        <c:varyColors val="0"/>
        <c:ser>
          <c:idx val="5"/>
          <c:order val="0"/>
          <c:tx>
            <c:strRef>
              <c:f>'CT-L'!$BT$78</c:f>
              <c:strCache>
                <c:ptCount val="1"/>
                <c:pt idx="0">
                  <c:v>1 Hrs + 10mM NAC</c:v>
                </c:pt>
              </c:strCache>
              <c:extLst xmlns:c15="http://schemas.microsoft.com/office/drawing/2012/chart"/>
            </c:strRef>
          </c:tx>
          <c:spPr>
            <a:solidFill>
              <a:schemeClr val="bg2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T-L'!$Z$30:$AB$30</c:f>
                <c:numCache>
                  <c:formatCode>General</c:formatCode>
                  <c:ptCount val="3"/>
                  <c:pt idx="0">
                    <c:v>5.0189025924515995</c:v>
                  </c:pt>
                  <c:pt idx="1">
                    <c:v>9.7779656661528751</c:v>
                  </c:pt>
                  <c:pt idx="2">
                    <c:v>12.317179545956149</c:v>
                  </c:pt>
                </c:numCache>
                <c:extLst xmlns:c15="http://schemas.microsoft.com/office/drawing/2012/chart"/>
              </c:numRef>
            </c:plus>
            <c:minus>
              <c:numRef>
                <c:f>'CT-L'!$Z$30:$AB$30</c:f>
                <c:numCache>
                  <c:formatCode>General</c:formatCode>
                  <c:ptCount val="3"/>
                  <c:pt idx="0">
                    <c:v>5.0189025924515995</c:v>
                  </c:pt>
                  <c:pt idx="1">
                    <c:v>9.7779656661528751</c:v>
                  </c:pt>
                  <c:pt idx="2">
                    <c:v>12.317179545956149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  <c:extLst xmlns:c15="http://schemas.microsoft.com/office/drawing/2012/chart"/>
            </c:strRef>
          </c:cat>
          <c:val>
            <c:numRef>
              <c:f>'CT-L'!$T$29:$V$29</c:f>
              <c:numCache>
                <c:formatCode>General</c:formatCode>
                <c:ptCount val="3"/>
                <c:pt idx="0">
                  <c:v>92.669172932330824</c:v>
                </c:pt>
                <c:pt idx="1">
                  <c:v>77.675840978593271</c:v>
                </c:pt>
                <c:pt idx="2">
                  <c:v>86.20828307197425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540E-45F9-A3D1-625B9FF8AC11}"/>
            </c:ext>
          </c:extLst>
        </c:ser>
        <c:ser>
          <c:idx val="1"/>
          <c:order val="2"/>
          <c:tx>
            <c:strRef>
              <c:f>'CT-L'!$BT$76</c:f>
              <c:strCache>
                <c:ptCount val="1"/>
                <c:pt idx="0">
                  <c:v>4 Hrs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0.14204404236890306</c:v>
                </c:pt>
                <c:pt idx="1">
                  <c:v>2.3741786631029473</c:v>
                </c:pt>
                <c:pt idx="2">
                  <c:v>3.570270175623397</c:v>
                </c:pt>
              </c:numLit>
            </c:plus>
            <c:minus>
              <c:numLit>
                <c:formatCode>General</c:formatCode>
                <c:ptCount val="3"/>
                <c:pt idx="0">
                  <c:v>0.14204404236890306</c:v>
                </c:pt>
                <c:pt idx="1">
                  <c:v>2.3741786631029473</c:v>
                </c:pt>
                <c:pt idx="2">
                  <c:v>3.570270175623397</c:v>
                </c:pt>
              </c:numLit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Lit>
              <c:formatCode>General</c:formatCode>
              <c:ptCount val="3"/>
              <c:pt idx="0">
                <c:v>68.470124753775437</c:v>
              </c:pt>
              <c:pt idx="1">
                <c:v>63.861125723303537</c:v>
              </c:pt>
              <c:pt idx="2">
                <c:v>64.740981828044468</c:v>
              </c:pt>
            </c:numLit>
          </c:val>
          <c:extLst>
            <c:ext xmlns:c16="http://schemas.microsoft.com/office/drawing/2014/chart" uri="{C3380CC4-5D6E-409C-BE32-E72D297353CC}">
              <c16:uniqueId val="{00000001-540E-45F9-A3D1-625B9FF8AC11}"/>
            </c:ext>
          </c:extLst>
        </c:ser>
        <c:ser>
          <c:idx val="0"/>
          <c:order val="3"/>
          <c:tx>
            <c:strRef>
              <c:f>'CT-L'!$BT$75</c:f>
              <c:strCache>
                <c:ptCount val="1"/>
                <c:pt idx="0">
                  <c:v>6 Hrs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T-L'!$BE$30:$BG$30</c:f>
                <c:numCache>
                  <c:formatCode>General</c:formatCode>
                  <c:ptCount val="3"/>
                  <c:pt idx="0">
                    <c:v>2.9995168064386579</c:v>
                  </c:pt>
                  <c:pt idx="1">
                    <c:v>3.8671290323905789</c:v>
                  </c:pt>
                  <c:pt idx="2">
                    <c:v>1.3106656993872037</c:v>
                  </c:pt>
                </c:numCache>
              </c:numRef>
            </c:plus>
            <c:minus>
              <c:numRef>
                <c:f>'CT-L'!$BE$30:$BG$30</c:f>
                <c:numCache>
                  <c:formatCode>General</c:formatCode>
                  <c:ptCount val="3"/>
                  <c:pt idx="0">
                    <c:v>2.9995168064386579</c:v>
                  </c:pt>
                  <c:pt idx="1">
                    <c:v>3.8671290323905789</c:v>
                  </c:pt>
                  <c:pt idx="2">
                    <c:v>1.3106656993872037</c:v>
                  </c:pt>
                </c:numCache>
              </c:numRef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AY$29:$BA$29</c:f>
              <c:numCache>
                <c:formatCode>General</c:formatCode>
                <c:ptCount val="3"/>
                <c:pt idx="0">
                  <c:v>118.72742906276871</c:v>
                </c:pt>
                <c:pt idx="1">
                  <c:v>163.73390557939913</c:v>
                </c:pt>
                <c:pt idx="2">
                  <c:v>132.182705718270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40E-45F9-A3D1-625B9FF8AC11}"/>
            </c:ext>
          </c:extLst>
        </c:ser>
        <c:ser>
          <c:idx val="3"/>
          <c:order val="4"/>
          <c:tx>
            <c:strRef>
              <c:f>'CT-L'!$BT$74</c:f>
              <c:strCache>
                <c:ptCount val="1"/>
                <c:pt idx="0">
                  <c:v>8 Hrs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T-L'!$BU$30:$BW$30</c:f>
                <c:numCache>
                  <c:formatCode>General</c:formatCode>
                  <c:ptCount val="3"/>
                  <c:pt idx="0">
                    <c:v>3.6114727899513297</c:v>
                  </c:pt>
                  <c:pt idx="1">
                    <c:v>6.5993666586617081</c:v>
                  </c:pt>
                  <c:pt idx="2">
                    <c:v>11.313201975987235</c:v>
                  </c:pt>
                </c:numCache>
              </c:numRef>
            </c:plus>
            <c:minus>
              <c:numRef>
                <c:f>'CT-L'!$BU$30:$BW$30</c:f>
                <c:numCache>
                  <c:formatCode>General</c:formatCode>
                  <c:ptCount val="3"/>
                  <c:pt idx="0">
                    <c:v>3.6114727899513297</c:v>
                  </c:pt>
                  <c:pt idx="1">
                    <c:v>6.5993666586617081</c:v>
                  </c:pt>
                  <c:pt idx="2">
                    <c:v>11.313201975987235</c:v>
                  </c:pt>
                </c:numCache>
              </c:numRef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BO$29:$BQ$29</c:f>
              <c:numCache>
                <c:formatCode>General</c:formatCode>
                <c:ptCount val="3"/>
                <c:pt idx="0">
                  <c:v>123.61134995700775</c:v>
                </c:pt>
                <c:pt idx="1">
                  <c:v>132.83261802575109</c:v>
                </c:pt>
                <c:pt idx="2">
                  <c:v>122.907949790794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40E-45F9-A3D1-625B9FF8AC11}"/>
            </c:ext>
          </c:extLst>
        </c:ser>
        <c:ser>
          <c:idx val="4"/>
          <c:order val="5"/>
          <c:tx>
            <c:strRef>
              <c:f>'CT-L'!$BT$79</c:f>
              <c:strCache>
                <c:ptCount val="1"/>
                <c:pt idx="0">
                  <c:v>8 Hrs BTZ</c:v>
                </c:pt>
              </c:strCache>
              <c:extLst xmlns:c15="http://schemas.microsoft.com/office/drawing/2012/chart"/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T-L'!$BL$34:$BN$34</c:f>
                <c:numCache>
                  <c:formatCode>General</c:formatCode>
                  <c:ptCount val="3"/>
                  <c:pt idx="0">
                    <c:v>5.9771799468991418</c:v>
                  </c:pt>
                  <c:pt idx="1">
                    <c:v>3.2402722898157719</c:v>
                  </c:pt>
                  <c:pt idx="2">
                    <c:v>4.4690292803381082</c:v>
                  </c:pt>
                </c:numCache>
                <c:extLst xmlns:c15="http://schemas.microsoft.com/office/drawing/2012/chart"/>
              </c:numRef>
            </c:plus>
            <c:minus>
              <c:numRef>
                <c:f>'CT-L'!$BL$34:$BN$34</c:f>
                <c:numCache>
                  <c:formatCode>General</c:formatCode>
                  <c:ptCount val="3"/>
                  <c:pt idx="0">
                    <c:v>5.9771799468991418</c:v>
                  </c:pt>
                  <c:pt idx="1">
                    <c:v>3.2402722898157719</c:v>
                  </c:pt>
                  <c:pt idx="2">
                    <c:v>4.4690292803381082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  <c:extLst xmlns:c15="http://schemas.microsoft.com/office/drawing/2012/chart"/>
            </c:strRef>
          </c:cat>
          <c:val>
            <c:numRef>
              <c:f>'CT-L'!$BL$33:$BN$33</c:f>
              <c:numCache>
                <c:formatCode>General</c:formatCode>
                <c:ptCount val="3"/>
                <c:pt idx="0">
                  <c:v>77.489251934651762</c:v>
                </c:pt>
                <c:pt idx="1">
                  <c:v>73.927038626609431</c:v>
                </c:pt>
                <c:pt idx="2">
                  <c:v>65.620641562064165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6-540E-45F9-A3D1-625B9FF8AC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0"/>
        <c:overlap val="-50"/>
        <c:axId val="38906032"/>
        <c:axId val="89684432"/>
        <c:extLst>
          <c:ext xmlns:c15="http://schemas.microsoft.com/office/drawing/2012/chart" uri="{02D57815-91ED-43cb-92C2-25804820EDAC}">
            <c15:filteredBarSeries>
              <c15:ser>
                <c:idx val="2"/>
                <c:order val="1"/>
                <c:tx>
                  <c:strRef>
                    <c:extLst>
                      <c:ext uri="{02D57815-91ED-43cb-92C2-25804820EDAC}">
                        <c15:formulaRef>
                          <c15:sqref>'CT-L'!$BT$77</c15:sqref>
                        </c15:formulaRef>
                      </c:ext>
                    </c:extLst>
                    <c:strCache>
                      <c:ptCount val="1"/>
                      <c:pt idx="0">
                        <c:v>1 Hrs</c:v>
                      </c:pt>
                    </c:strCache>
                  </c:strRef>
                </c:tx>
                <c:spPr>
                  <a:solidFill>
                    <a:schemeClr val="tx2">
                      <a:lumMod val="20000"/>
                      <a:lumOff val="80000"/>
                    </a:schemeClr>
                  </a:solidFill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CT-L'!$AO$30:$AQ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8.0309912523252471</c:v>
                        </c:pt>
                        <c:pt idx="1">
                          <c:v>4.8852156385545973</c:v>
                        </c:pt>
                        <c:pt idx="2">
                          <c:v>5.2990575990178073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CT-L'!$AO$30:$AQ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8.0309912523252471</c:v>
                        </c:pt>
                        <c:pt idx="1">
                          <c:v>4.8852156385545973</c:v>
                        </c:pt>
                        <c:pt idx="2">
                          <c:v>5.2990575990178073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CT-L'!$Z$19:$AB$19</c15:sqref>
                        </c15:formulaRef>
                      </c:ext>
                    </c:extLst>
                    <c:strCache>
                      <c:ptCount val="3"/>
                      <c:pt idx="0">
                        <c:v>CT-L</c:v>
                      </c:pt>
                      <c:pt idx="1">
                        <c:v>T-L</c:v>
                      </c:pt>
                      <c:pt idx="2">
                        <c:v>C-L</c:v>
                      </c:pt>
                    </c:strCache>
                  </c:strRef>
                </c:cat>
                <c:val>
                  <c:numLit>
                    <c:formatCode>General</c:formatCode>
                    <c:ptCount val="3"/>
                    <c:pt idx="0">
                      <c:v>130.53184504267892</c:v>
                    </c:pt>
                    <c:pt idx="1">
                      <c:v>109.9947396107312</c:v>
                    </c:pt>
                    <c:pt idx="2">
                      <c:v>134.391103878492</c:v>
                    </c:pt>
                  </c:numLit>
                </c:val>
                <c:extLst>
                  <c:ext xmlns:c16="http://schemas.microsoft.com/office/drawing/2014/chart" uri="{C3380CC4-5D6E-409C-BE32-E72D297353CC}">
                    <c16:uniqueId val="{00000005-540E-45F9-A3D1-625B9FF8AC11}"/>
                  </c:ext>
                </c:extLst>
              </c15:ser>
            </c15:filteredBarSeries>
          </c:ext>
        </c:extLst>
      </c:barChart>
      <c:valAx>
        <c:axId val="96838320"/>
        <c:scaling>
          <c:orientation val="minMax"/>
          <c:max val="18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% Proteasome activity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90515824"/>
        <c:crosses val="autoZero"/>
        <c:crossBetween val="between"/>
      </c:valAx>
      <c:catAx>
        <c:axId val="90515824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dirty="0"/>
                  <a:t>CT-L                T-L                  C-L</a:t>
                </a:r>
              </a:p>
            </c:rich>
          </c:tx>
          <c:layout>
            <c:manualLayout>
              <c:xMode val="edge"/>
              <c:yMode val="edge"/>
              <c:x val="0.21525171528975856"/>
              <c:y val="0.8910306322046449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6838320"/>
        <c:crosses val="autoZero"/>
        <c:auto val="1"/>
        <c:lblAlgn val="ctr"/>
        <c:lblOffset val="100"/>
        <c:noMultiLvlLbl val="0"/>
      </c:catAx>
      <c:valAx>
        <c:axId val="89684432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38906032"/>
        <c:crosses val="max"/>
        <c:crossBetween val="between"/>
      </c:valAx>
      <c:catAx>
        <c:axId val="389060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9684432"/>
        <c:crosses val="autoZero"/>
        <c:auto val="1"/>
        <c:lblAlgn val="ctr"/>
        <c:lblOffset val="100"/>
        <c:noMultiLvlLbl val="0"/>
      </c:catAx>
      <c:spPr>
        <a:pattFill prst="pct5">
          <a:fgClr>
            <a:schemeClr val="bg2"/>
          </a:fgClr>
          <a:bgClr>
            <a:schemeClr val="bg1"/>
          </a:bgClr>
        </a:pattFill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80026511400594724"/>
          <c:y val="0.1775269096750407"/>
          <c:w val="0.15685656234157166"/>
          <c:h val="0.71749146886191906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0" i="0" baseline="0">
                <a:solidFill>
                  <a:sysClr val="windowText" lastClr="000000"/>
                </a:solidFill>
                <a:effectLst/>
              </a:rPr>
              <a:t>BT399 Proteasome Inhibition</a:t>
            </a:r>
            <a:endParaRPr lang="en-US">
              <a:solidFill>
                <a:sysClr val="windowText" lastClr="000000"/>
              </a:solidFill>
              <a:effectLst/>
            </a:endParaRPr>
          </a:p>
        </c:rich>
      </c:tx>
      <c:layout>
        <c:manualLayout>
          <c:xMode val="edge"/>
          <c:yMode val="edge"/>
          <c:x val="0.12198618023806769"/>
          <c:y val="5.08670520231213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3236722867448047"/>
          <c:y val="0.17595760303719776"/>
          <c:w val="0.6641988168459757"/>
          <c:h val="0.71445961653073253"/>
        </c:manualLayout>
      </c:layout>
      <c:barChart>
        <c:barDir val="col"/>
        <c:grouping val="clustered"/>
        <c:varyColors val="0"/>
        <c:ser>
          <c:idx val="6"/>
          <c:order val="6"/>
          <c:tx>
            <c:strRef>
              <c:f>'CT-L'!$BT$73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rgbClr val="FFFFFF"/>
            </a:solidFill>
            <a:ln cap="sq">
              <a:solidFill>
                <a:schemeClr val="tx1"/>
              </a:solidFill>
              <a:round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T-L'!$BB$34:$BD$34</c:f>
                <c:numCache>
                  <c:formatCode>General</c:formatCode>
                  <c:ptCount val="3"/>
                  <c:pt idx="0">
                    <c:v>8.6606862173205261</c:v>
                  </c:pt>
                  <c:pt idx="1">
                    <c:v>3.7584291605444187</c:v>
                  </c:pt>
                  <c:pt idx="2">
                    <c:v>2.9825475793688816</c:v>
                  </c:pt>
                </c:numCache>
              </c:numRef>
            </c:plus>
            <c:minus>
              <c:numRef>
                <c:f>'CT-L'!$BB$34:$BD$34</c:f>
                <c:numCache>
                  <c:formatCode>General</c:formatCode>
                  <c:ptCount val="3"/>
                  <c:pt idx="0">
                    <c:v>8.6606862173205261</c:v>
                  </c:pt>
                  <c:pt idx="1">
                    <c:v>3.7584291605444187</c:v>
                  </c:pt>
                  <c:pt idx="2">
                    <c:v>2.9825475793688816</c:v>
                  </c:pt>
                </c:numCache>
              </c:numRef>
            </c:minus>
          </c:errBars>
          <c:cat>
            <c:strRef>
              <c:f>'CT-L'!$AL$32:$AN$32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BB$33:$BD$33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A1-4134-A5DC-B5BDF1059A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5"/>
        <c:overlap val="20"/>
        <c:axId val="90515824"/>
        <c:axId val="96838320"/>
      </c:barChart>
      <c:barChart>
        <c:barDir val="col"/>
        <c:grouping val="clustered"/>
        <c:varyColors val="0"/>
        <c:ser>
          <c:idx val="1"/>
          <c:order val="2"/>
          <c:tx>
            <c:strRef>
              <c:f>'CT-L'!$BT$76</c:f>
              <c:strCache>
                <c:ptCount val="1"/>
                <c:pt idx="0">
                  <c:v>4 Hrs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0.14204404236890306</c:v>
                </c:pt>
                <c:pt idx="1">
                  <c:v>2.3741786631029473</c:v>
                </c:pt>
                <c:pt idx="2">
                  <c:v>3.570270175623397</c:v>
                </c:pt>
              </c:numLit>
            </c:plus>
            <c:minus>
              <c:numLit>
                <c:formatCode>General</c:formatCode>
                <c:ptCount val="3"/>
                <c:pt idx="0">
                  <c:v>0.14204404236890306</c:v>
                </c:pt>
                <c:pt idx="1">
                  <c:v>2.3741786631029473</c:v>
                </c:pt>
                <c:pt idx="2">
                  <c:v>3.570270175623397</c:v>
                </c:pt>
              </c:numLit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Lit>
              <c:formatCode>General</c:formatCode>
              <c:ptCount val="3"/>
              <c:pt idx="0">
                <c:v>50.098489822718321</c:v>
              </c:pt>
              <c:pt idx="1">
                <c:v>50.341925302472383</c:v>
              </c:pt>
              <c:pt idx="2">
                <c:v>51.152698671006235</c:v>
              </c:pt>
            </c:numLit>
          </c:val>
          <c:extLst>
            <c:ext xmlns:c16="http://schemas.microsoft.com/office/drawing/2014/chart" uri="{C3380CC4-5D6E-409C-BE32-E72D297353CC}">
              <c16:uniqueId val="{00000001-27A1-4134-A5DC-B5BDF1059A00}"/>
            </c:ext>
          </c:extLst>
        </c:ser>
        <c:ser>
          <c:idx val="0"/>
          <c:order val="3"/>
          <c:tx>
            <c:strRef>
              <c:f>'CT-L'!$BT$75</c:f>
              <c:strCache>
                <c:ptCount val="1"/>
                <c:pt idx="0">
                  <c:v>6 Hrs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T-L'!$BE$30:$BG$30</c:f>
                <c:numCache>
                  <c:formatCode>General</c:formatCode>
                  <c:ptCount val="3"/>
                  <c:pt idx="0">
                    <c:v>2.9995168064386579</c:v>
                  </c:pt>
                  <c:pt idx="1">
                    <c:v>3.8671290323905789</c:v>
                  </c:pt>
                  <c:pt idx="2">
                    <c:v>1.3106656993872037</c:v>
                  </c:pt>
                </c:numCache>
              </c:numRef>
            </c:plus>
            <c:minus>
              <c:numRef>
                <c:f>'CT-L'!$BE$30:$BG$30</c:f>
                <c:numCache>
                  <c:formatCode>General</c:formatCode>
                  <c:ptCount val="3"/>
                  <c:pt idx="0">
                    <c:v>2.9995168064386579</c:v>
                  </c:pt>
                  <c:pt idx="1">
                    <c:v>3.8671290323905789</c:v>
                  </c:pt>
                  <c:pt idx="2">
                    <c:v>1.3106656993872037</c:v>
                  </c:pt>
                </c:numCache>
              </c:numRef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BB$29:$BD$29</c:f>
              <c:numCache>
                <c:formatCode>General</c:formatCode>
                <c:ptCount val="3"/>
                <c:pt idx="0">
                  <c:v>67.343078245915734</c:v>
                </c:pt>
                <c:pt idx="1">
                  <c:v>96.566523605150209</c:v>
                </c:pt>
                <c:pt idx="2">
                  <c:v>85.56485355648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7A1-4134-A5DC-B5BDF1059A00}"/>
            </c:ext>
          </c:extLst>
        </c:ser>
        <c:ser>
          <c:idx val="3"/>
          <c:order val="4"/>
          <c:tx>
            <c:strRef>
              <c:f>'CT-L'!$BT$74</c:f>
              <c:strCache>
                <c:ptCount val="1"/>
                <c:pt idx="0">
                  <c:v>8 Hrs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T-L'!$BU$30:$BW$30</c:f>
                <c:numCache>
                  <c:formatCode>General</c:formatCode>
                  <c:ptCount val="3"/>
                  <c:pt idx="0">
                    <c:v>3.6114727899513297</c:v>
                  </c:pt>
                  <c:pt idx="1">
                    <c:v>6.5993666586617081</c:v>
                  </c:pt>
                  <c:pt idx="2">
                    <c:v>11.313201975987235</c:v>
                  </c:pt>
                </c:numCache>
              </c:numRef>
            </c:plus>
            <c:minus>
              <c:numRef>
                <c:f>'CT-L'!$BU$30:$BW$30</c:f>
                <c:numCache>
                  <c:formatCode>General</c:formatCode>
                  <c:ptCount val="3"/>
                  <c:pt idx="0">
                    <c:v>3.6114727899513297</c:v>
                  </c:pt>
                  <c:pt idx="1">
                    <c:v>6.5993666586617081</c:v>
                  </c:pt>
                  <c:pt idx="2">
                    <c:v>11.313201975987235</c:v>
                  </c:pt>
                </c:numCache>
              </c:numRef>
            </c:minus>
          </c:errBars>
          <c:cat>
            <c:strRef>
              <c:f>'CT-L'!$Z$19:$AB$19</c:f>
              <c:strCache>
                <c:ptCount val="3"/>
                <c:pt idx="0">
                  <c:v>CT-L</c:v>
                </c:pt>
                <c:pt idx="1">
                  <c:v>T-L</c:v>
                </c:pt>
                <c:pt idx="2">
                  <c:v>C-L</c:v>
                </c:pt>
              </c:strCache>
            </c:strRef>
          </c:cat>
          <c:val>
            <c:numRef>
              <c:f>'CT-L'!$BR$29:$BT$29</c:f>
              <c:numCache>
                <c:formatCode>General</c:formatCode>
                <c:ptCount val="3"/>
                <c:pt idx="0">
                  <c:v>77.334479793637144</c:v>
                </c:pt>
                <c:pt idx="1">
                  <c:v>102.78969957081544</c:v>
                </c:pt>
                <c:pt idx="2">
                  <c:v>94.2119944211994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7A1-4134-A5DC-B5BDF1059A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0"/>
        <c:overlap val="-50"/>
        <c:axId val="38906032"/>
        <c:axId val="89684432"/>
        <c:extLst>
          <c:ext xmlns:c15="http://schemas.microsoft.com/office/drawing/2012/chart" uri="{02D57815-91ED-43cb-92C2-25804820EDAC}">
            <c15:filteredBarSeries>
              <c15:ser>
                <c:idx val="5"/>
                <c:order val="0"/>
                <c:tx>
                  <c:strRef>
                    <c:extLst>
                      <c:ext uri="{02D57815-91ED-43cb-92C2-25804820EDAC}">
                        <c15:formulaRef>
                          <c15:sqref>'CT-L'!$BT$78</c15:sqref>
                        </c15:formulaRef>
                      </c:ext>
                    </c:extLst>
                    <c:strCache>
                      <c:ptCount val="1"/>
                      <c:pt idx="0">
                        <c:v>1 Hrs + 10mM NAC</c:v>
                      </c:pt>
                    </c:strCache>
                  </c:strRef>
                </c:tx>
                <c:spPr>
                  <a:solidFill>
                    <a:schemeClr val="bg2">
                      <a:lumMod val="75000"/>
                    </a:schemeClr>
                  </a:solidFill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CT-L'!$Z$30:$AB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5.0189025924515995</c:v>
                        </c:pt>
                        <c:pt idx="1">
                          <c:v>9.7779656661528751</c:v>
                        </c:pt>
                        <c:pt idx="2">
                          <c:v>12.317179545956149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CT-L'!$Z$30:$AB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5.0189025924515995</c:v>
                        </c:pt>
                        <c:pt idx="1">
                          <c:v>9.7779656661528751</c:v>
                        </c:pt>
                        <c:pt idx="2">
                          <c:v>12.317179545956149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CT-L'!$Z$19:$AB$19</c15:sqref>
                        </c15:formulaRef>
                      </c:ext>
                    </c:extLst>
                    <c:strCache>
                      <c:ptCount val="3"/>
                      <c:pt idx="0">
                        <c:v>CT-L</c:v>
                      </c:pt>
                      <c:pt idx="1">
                        <c:v>T-L</c:v>
                      </c:pt>
                      <c:pt idx="2">
                        <c:v>C-L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CT-L'!$W$29:$Y$29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68.026315789473685</c:v>
                      </c:pt>
                      <c:pt idx="1">
                        <c:v>72.171253822629964</c:v>
                      </c:pt>
                      <c:pt idx="2">
                        <c:v>65.621230398069969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4-27A1-4134-A5DC-B5BDF1059A00}"/>
                  </c:ext>
                </c:extLst>
              </c15:ser>
            </c15:filteredBarSeries>
            <c15:filteredBarSeries>
              <c15:ser>
                <c:idx val="2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BT$77</c15:sqref>
                        </c15:formulaRef>
                      </c:ext>
                    </c:extLst>
                    <c:strCache>
                      <c:ptCount val="1"/>
                      <c:pt idx="0">
                        <c:v>1 Hrs</c:v>
                      </c:pt>
                    </c:strCache>
                  </c:strRef>
                </c:tx>
                <c:spPr>
                  <a:solidFill>
                    <a:schemeClr val="tx2">
                      <a:lumMod val="20000"/>
                      <a:lumOff val="80000"/>
                    </a:schemeClr>
                  </a:solidFill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CT-L'!$AO$30:$AQ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8.0309912523252471</c:v>
                        </c:pt>
                        <c:pt idx="1">
                          <c:v>4.8852156385545973</c:v>
                        </c:pt>
                        <c:pt idx="2">
                          <c:v>5.2990575990178073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CT-L'!$AO$30:$AQ$30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8.0309912523252471</c:v>
                        </c:pt>
                        <c:pt idx="1">
                          <c:v>4.8852156385545973</c:v>
                        </c:pt>
                        <c:pt idx="2">
                          <c:v>5.2990575990178073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Z$19:$AB$19</c15:sqref>
                        </c15:formulaRef>
                      </c:ext>
                    </c:extLst>
                    <c:strCache>
                      <c:ptCount val="3"/>
                      <c:pt idx="0">
                        <c:v>CT-L</c:v>
                      </c:pt>
                      <c:pt idx="1">
                        <c:v>T-L</c:v>
                      </c:pt>
                      <c:pt idx="2">
                        <c:v>C-L</c:v>
                      </c:pt>
                    </c:strCache>
                  </c:strRef>
                </c:cat>
                <c:val>
                  <c:numLit>
                    <c:formatCode>General</c:formatCode>
                    <c:ptCount val="3"/>
                    <c:pt idx="0">
                      <c:v>108.10242941562704</c:v>
                    </c:pt>
                    <c:pt idx="1">
                      <c:v>106.83850604944766</c:v>
                    </c:pt>
                    <c:pt idx="2">
                      <c:v>132.00433957146731</c:v>
                    </c:pt>
                  </c:numLit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27A1-4134-A5DC-B5BDF1059A00}"/>
                  </c:ext>
                </c:extLst>
              </c15:ser>
            </c15:filteredBarSeries>
            <c15:filteredBarSeries>
              <c15:ser>
                <c:idx val="4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BT$79</c15:sqref>
                        </c15:formulaRef>
                      </c:ext>
                    </c:extLst>
                    <c:strCache>
                      <c:ptCount val="1"/>
                      <c:pt idx="0">
                        <c:v>8 Hrs BTZ</c:v>
                      </c:pt>
                    </c:strCache>
                  </c:strRef>
                </c:tx>
                <c:spPr>
                  <a:solidFill>
                    <a:schemeClr val="bg1">
                      <a:lumMod val="50000"/>
                    </a:schemeClr>
                  </a:solidFill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CT-L'!$BL$34:$BN$34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5.9771799468991418</c:v>
                        </c:pt>
                        <c:pt idx="1">
                          <c:v>3.2402722898157719</c:v>
                        </c:pt>
                        <c:pt idx="2">
                          <c:v>4.4690292803381082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CT-L'!$BL$34:$BN$34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5.9771799468991418</c:v>
                        </c:pt>
                        <c:pt idx="1">
                          <c:v>3.2402722898157719</c:v>
                        </c:pt>
                        <c:pt idx="2">
                          <c:v>4.4690292803381082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Z$19:$AB$19</c15:sqref>
                        </c15:formulaRef>
                      </c:ext>
                    </c:extLst>
                    <c:strCache>
                      <c:ptCount val="3"/>
                      <c:pt idx="0">
                        <c:v>CT-L</c:v>
                      </c:pt>
                      <c:pt idx="1">
                        <c:v>T-L</c:v>
                      </c:pt>
                      <c:pt idx="2">
                        <c:v>C-L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T-L'!$BL$33:$BN$33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77.489251934651762</c:v>
                      </c:pt>
                      <c:pt idx="1">
                        <c:v>73.927038626609431</c:v>
                      </c:pt>
                      <c:pt idx="2">
                        <c:v>65.620641562064165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27A1-4134-A5DC-B5BDF1059A00}"/>
                  </c:ext>
                </c:extLst>
              </c15:ser>
            </c15:filteredBarSeries>
          </c:ext>
        </c:extLst>
      </c:barChart>
      <c:valAx>
        <c:axId val="96838320"/>
        <c:scaling>
          <c:orientation val="minMax"/>
          <c:max val="12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% Proteasome activity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90515824"/>
        <c:crosses val="autoZero"/>
        <c:crossBetween val="between"/>
      </c:valAx>
      <c:catAx>
        <c:axId val="90515824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dirty="0"/>
                  <a:t>CT-L                       T-L                C-L</a:t>
                </a:r>
              </a:p>
            </c:rich>
          </c:tx>
          <c:layout>
            <c:manualLayout>
              <c:xMode val="edge"/>
              <c:yMode val="edge"/>
              <c:x val="0.21169879602101241"/>
              <c:y val="0.8889287182191659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6838320"/>
        <c:crosses val="autoZero"/>
        <c:auto val="1"/>
        <c:lblAlgn val="ctr"/>
        <c:lblOffset val="100"/>
        <c:noMultiLvlLbl val="0"/>
      </c:catAx>
      <c:valAx>
        <c:axId val="89684432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38906032"/>
        <c:crosses val="max"/>
        <c:crossBetween val="between"/>
      </c:valAx>
      <c:catAx>
        <c:axId val="389060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9684432"/>
        <c:crosses val="autoZero"/>
        <c:auto val="1"/>
        <c:lblAlgn val="ctr"/>
        <c:lblOffset val="100"/>
        <c:noMultiLvlLbl val="0"/>
      </c:catAx>
      <c:spPr>
        <a:pattFill prst="pct5">
          <a:fgClr>
            <a:schemeClr val="bg2"/>
          </a:fgClr>
          <a:bgClr>
            <a:schemeClr val="bg1"/>
          </a:bgClr>
        </a:pattFill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80009697525473478"/>
          <c:y val="0.1816151412079644"/>
          <c:w val="0.14824132263717471"/>
          <c:h val="0.70891732328836587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0425287-A8E9-49B3-A6D3-E5035AD5CDC0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05075" y="1162050"/>
            <a:ext cx="200025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093A72B4-A708-47B5-9C1C-EF0A263A9DF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7348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995312"/>
            <a:ext cx="6606540" cy="4244622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6403623"/>
            <a:ext cx="5829300" cy="2943577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743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79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649111"/>
            <a:ext cx="1675924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649111"/>
            <a:ext cx="4930616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866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606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3039537"/>
            <a:ext cx="6703695" cy="5071532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8159048"/>
            <a:ext cx="6703695" cy="2666999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568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3245556"/>
            <a:ext cx="330327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3245556"/>
            <a:ext cx="330327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739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49114"/>
            <a:ext cx="670369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988734"/>
            <a:ext cx="3288089" cy="1464732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4453467"/>
            <a:ext cx="328808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988734"/>
            <a:ext cx="3304282" cy="1464732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4453467"/>
            <a:ext cx="3304282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30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064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900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812800"/>
            <a:ext cx="2506801" cy="28448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755425"/>
            <a:ext cx="3934778" cy="8664222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657600"/>
            <a:ext cx="2506801" cy="6776156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512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812800"/>
            <a:ext cx="2506801" cy="28448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755425"/>
            <a:ext cx="3934778" cy="8664222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657600"/>
            <a:ext cx="2506801" cy="6776156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94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649114"/>
            <a:ext cx="670369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3245556"/>
            <a:ext cx="670369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11300181"/>
            <a:ext cx="174879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40017-FBCF-441D-AC65-1AC7FD560399}" type="datetimeFigureOut">
              <a:rPr lang="en-US" smtClean="0"/>
              <a:pPr/>
              <a:t>10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11300181"/>
            <a:ext cx="262318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11300181"/>
            <a:ext cx="174879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4B1BC-9297-4365-B618-6A384060B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236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chart" Target="../charts/chart2.xml"/><Relationship Id="rId7" Type="http://schemas.openxmlformats.org/officeDocument/2006/relationships/oleObject" Target="../embeddings/oleObject6.bin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5.bin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13" Type="http://schemas.openxmlformats.org/officeDocument/2006/relationships/image" Target="../media/image15.png"/><Relationship Id="rId18" Type="http://schemas.openxmlformats.org/officeDocument/2006/relationships/image" Target="../media/image18.emf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12" Type="http://schemas.openxmlformats.org/officeDocument/2006/relationships/image" Target="../media/image14.png"/><Relationship Id="rId17" Type="http://schemas.openxmlformats.org/officeDocument/2006/relationships/oleObject" Target="../embeddings/oleObject13.bin"/><Relationship Id="rId2" Type="http://schemas.openxmlformats.org/officeDocument/2006/relationships/oleObject" Target="../embeddings/oleObject8.bin"/><Relationship Id="rId16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13.png"/><Relationship Id="rId5" Type="http://schemas.openxmlformats.org/officeDocument/2006/relationships/image" Target="../media/image9.emf"/><Relationship Id="rId15" Type="http://schemas.openxmlformats.org/officeDocument/2006/relationships/oleObject" Target="../embeddings/oleObject12.bin"/><Relationship Id="rId10" Type="http://schemas.openxmlformats.org/officeDocument/2006/relationships/image" Target="../media/image12.png"/><Relationship Id="rId4" Type="http://schemas.openxmlformats.org/officeDocument/2006/relationships/oleObject" Target="../embeddings/oleObject9.bin"/><Relationship Id="rId9" Type="http://schemas.openxmlformats.org/officeDocument/2006/relationships/image" Target="../media/image11.emf"/><Relationship Id="rId1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A988479-7DFE-9851-EB40-9CD0F08DD258}"/>
              </a:ext>
            </a:extLst>
          </p:cNvPr>
          <p:cNvSpPr txBox="1"/>
          <p:nvPr/>
        </p:nvSpPr>
        <p:spPr>
          <a:xfrm>
            <a:off x="766354" y="715121"/>
            <a:ext cx="5738949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Table 1. Genetic characteristics of the patient-derived (DB93, DB81) and established glioma lines (U-251MG, D-54MG, U-87, T98G, CHLA-200 and HOG) included in this study. </a:t>
            </a:r>
          </a:p>
        </p:txBody>
      </p:sp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CE33A305-D9D0-00E4-C1E6-DBC3F0F9A8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2644178"/>
              </p:ext>
            </p:extLst>
          </p:nvPr>
        </p:nvGraphicFramePr>
        <p:xfrm>
          <a:off x="1192587" y="1470509"/>
          <a:ext cx="5140169" cy="2759569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801849">
                  <a:extLst>
                    <a:ext uri="{9D8B030D-6E8A-4147-A177-3AD203B41FA5}">
                      <a16:colId xmlns:a16="http://schemas.microsoft.com/office/drawing/2014/main" val="688392434"/>
                    </a:ext>
                  </a:extLst>
                </a:gridCol>
                <a:gridCol w="1280160">
                  <a:extLst>
                    <a:ext uri="{9D8B030D-6E8A-4147-A177-3AD203B41FA5}">
                      <a16:colId xmlns:a16="http://schemas.microsoft.com/office/drawing/2014/main" val="570892476"/>
                    </a:ext>
                  </a:extLst>
                </a:gridCol>
                <a:gridCol w="550996">
                  <a:extLst>
                    <a:ext uri="{9D8B030D-6E8A-4147-A177-3AD203B41FA5}">
                      <a16:colId xmlns:a16="http://schemas.microsoft.com/office/drawing/2014/main" val="2736937522"/>
                    </a:ext>
                  </a:extLst>
                </a:gridCol>
                <a:gridCol w="677611">
                  <a:extLst>
                    <a:ext uri="{9D8B030D-6E8A-4147-A177-3AD203B41FA5}">
                      <a16:colId xmlns:a16="http://schemas.microsoft.com/office/drawing/2014/main" val="2108488895"/>
                    </a:ext>
                  </a:extLst>
                </a:gridCol>
                <a:gridCol w="609851">
                  <a:extLst>
                    <a:ext uri="{9D8B030D-6E8A-4147-A177-3AD203B41FA5}">
                      <a16:colId xmlns:a16="http://schemas.microsoft.com/office/drawing/2014/main" val="1565747417"/>
                    </a:ext>
                  </a:extLst>
                </a:gridCol>
                <a:gridCol w="467522">
                  <a:extLst>
                    <a:ext uri="{9D8B030D-6E8A-4147-A177-3AD203B41FA5}">
                      <a16:colId xmlns:a16="http://schemas.microsoft.com/office/drawing/2014/main" val="2175772416"/>
                    </a:ext>
                  </a:extLst>
                </a:gridCol>
                <a:gridCol w="752180">
                  <a:extLst>
                    <a:ext uri="{9D8B030D-6E8A-4147-A177-3AD203B41FA5}">
                      <a16:colId xmlns:a16="http://schemas.microsoft.com/office/drawing/2014/main" val="264398609"/>
                    </a:ext>
                  </a:extLst>
                </a:gridCol>
              </a:tblGrid>
              <a:tr h="236410">
                <a:tc gridSpan="6">
                  <a:txBody>
                    <a:bodyPr/>
                    <a:lstStyle/>
                    <a:p>
                      <a:pPr algn="ctr"/>
                      <a:endParaRPr lang="en-US" sz="700" dirty="0">
                        <a:solidFill>
                          <a:schemeClr val="tx1"/>
                        </a:solidFill>
                      </a:endParaRPr>
                    </a:p>
                  </a:txBody>
                  <a:tcPr marL="58293" marR="58293" marT="29146" marB="29146">
                    <a:lnT w="381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381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381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381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381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381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solidFill>
                          <a:schemeClr val="tx1"/>
                        </a:solidFill>
                      </a:endParaRPr>
                    </a:p>
                  </a:txBody>
                  <a:tcPr marL="58293" marR="58293" marT="29146" marB="29146">
                    <a:lnT w="381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3553833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chemeClr val="tx1"/>
                          </a:solidFill>
                        </a:rPr>
                        <a:t>Line</a:t>
                      </a:r>
                    </a:p>
                  </a:txBody>
                  <a:tcPr marL="58293" marR="58293" marT="29146" marB="29146">
                    <a:lnT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chemeClr val="tx1"/>
                          </a:solidFill>
                        </a:rPr>
                        <a:t>Classification</a:t>
                      </a:r>
                    </a:p>
                  </a:txBody>
                  <a:tcPr marL="58293" marR="58293" marT="29146" marB="29146">
                    <a:lnT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chemeClr val="tx1"/>
                          </a:solidFill>
                        </a:rPr>
                        <a:t>Grade</a:t>
                      </a:r>
                    </a:p>
                  </a:txBody>
                  <a:tcPr marL="58293" marR="58293" marT="29146" marB="29146">
                    <a:lnT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solidFill>
                            <a:schemeClr val="tx1"/>
                          </a:solidFill>
                        </a:rPr>
                        <a:t>IDH1</a:t>
                      </a:r>
                    </a:p>
                  </a:txBody>
                  <a:tcPr marL="58293" marR="58293" marT="29146" marB="29146">
                    <a:lnT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chemeClr val="tx1"/>
                          </a:solidFill>
                        </a:rPr>
                        <a:t>p53</a:t>
                      </a:r>
                    </a:p>
                  </a:txBody>
                  <a:tcPr marL="58293" marR="58293" marT="29146" marB="29146">
                    <a:lnT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chemeClr val="tx1"/>
                          </a:solidFill>
                        </a:rPr>
                        <a:t>ATRX</a:t>
                      </a:r>
                    </a:p>
                  </a:txBody>
                  <a:tcPr marL="58293" marR="58293" marT="29146" marB="29146">
                    <a:lnT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chemeClr val="tx1"/>
                          </a:solidFill>
                        </a:rPr>
                        <a:t>IC50 conc </a:t>
                      </a:r>
                    </a:p>
                    <a:p>
                      <a:pPr algn="ctr"/>
                      <a:r>
                        <a:rPr lang="en-US" sz="700" dirty="0">
                          <a:solidFill>
                            <a:schemeClr val="tx1"/>
                          </a:solidFill>
                        </a:rPr>
                        <a:t>of BT317 (µM)</a:t>
                      </a:r>
                    </a:p>
                  </a:txBody>
                  <a:tcPr marL="58293" marR="58293" marT="29146" marB="29146">
                    <a:lnT w="19050" cap="flat" cmpd="sng" algn="ctr"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7058195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B93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lioblastom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os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63.7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5385985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B81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rade IV Astrocytom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ut</a:t>
                      </a:r>
                      <a:endParaRPr lang="en-US" sz="11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os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os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97.2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8978409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U-251MG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lioblastom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u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2.06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6905218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-54MG</a:t>
                      </a:r>
                      <a:endParaRPr lang="en-US" sz="11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lioblastom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u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64.3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5523136"/>
                  </a:ext>
                </a:extLst>
              </a:tr>
              <a:tr h="282313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-87</a:t>
                      </a:r>
                      <a:endParaRPr lang="en-US" sz="11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lioblastom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u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5.9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6830508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98G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lioblastom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u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8.5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2755390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CHLA-200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strocytom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ilent Mu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5.8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666084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HOG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alignant Gliom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/4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WT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2.3</a:t>
                      </a:r>
                    </a:p>
                  </a:txBody>
                  <a:tcPr marL="58293" marR="58293" marT="29146" marB="29146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80986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5495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943653A-12AE-D1DA-57AE-40C625E93681}"/>
              </a:ext>
            </a:extLst>
          </p:cNvPr>
          <p:cNvSpPr txBox="1"/>
          <p:nvPr/>
        </p:nvSpPr>
        <p:spPr>
          <a:xfrm>
            <a:off x="2610492" y="761631"/>
            <a:ext cx="26413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ary Figure S1 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68905BA-14AB-47EF-44F6-1F0C866D9175}"/>
              </a:ext>
            </a:extLst>
          </p:cNvPr>
          <p:cNvSpPr txBox="1"/>
          <p:nvPr/>
        </p:nvSpPr>
        <p:spPr>
          <a:xfrm>
            <a:off x="690960" y="3434107"/>
            <a:ext cx="361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EEC843E-4E56-09AA-6A6D-51A2362F1C16}"/>
              </a:ext>
            </a:extLst>
          </p:cNvPr>
          <p:cNvSpPr txBox="1"/>
          <p:nvPr/>
        </p:nvSpPr>
        <p:spPr>
          <a:xfrm>
            <a:off x="713858" y="1807204"/>
            <a:ext cx="361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4430815-92EA-8004-9F34-553600F162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6183360"/>
              </p:ext>
            </p:extLst>
          </p:nvPr>
        </p:nvGraphicFramePr>
        <p:xfrm>
          <a:off x="1148010" y="5525227"/>
          <a:ext cx="5977695" cy="30815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7113960" imgH="3666960" progId="Prism5.Document">
                  <p:embed/>
                </p:oleObj>
              </mc:Choice>
              <mc:Fallback>
                <p:oleObj name="Prism 5" r:id="rId2" imgW="7113960" imgH="36669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48010" y="5525227"/>
                        <a:ext cx="5977695" cy="30815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1CBD461-3A52-FCCE-9300-7112350F4BF2}"/>
              </a:ext>
            </a:extLst>
          </p:cNvPr>
          <p:cNvSpPr txBox="1"/>
          <p:nvPr/>
        </p:nvSpPr>
        <p:spPr>
          <a:xfrm>
            <a:off x="690960" y="5518214"/>
            <a:ext cx="361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929DDD2-6975-D64D-19D4-F0E6616371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31967"/>
              </p:ext>
            </p:extLst>
          </p:nvPr>
        </p:nvGraphicFramePr>
        <p:xfrm>
          <a:off x="1010804" y="3434107"/>
          <a:ext cx="2988035" cy="1907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4" imgW="4997160" imgH="3191400" progId="Prism5.Document">
                  <p:embed/>
                </p:oleObj>
              </mc:Choice>
              <mc:Fallback>
                <p:oleObj name="Prism 5" r:id="rId4" imgW="4997160" imgH="3191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10804" y="3434107"/>
                        <a:ext cx="2988035" cy="1907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99A98331-51B6-9A73-1B2E-0329F8A162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2685206"/>
              </p:ext>
            </p:extLst>
          </p:nvPr>
        </p:nvGraphicFramePr>
        <p:xfrm>
          <a:off x="3934334" y="3207036"/>
          <a:ext cx="3396469" cy="2226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6" imgW="4617720" imgH="3026880" progId="Prism5.Document">
                  <p:embed/>
                </p:oleObj>
              </mc:Choice>
              <mc:Fallback>
                <p:oleObj name="Prism 5" r:id="rId6" imgW="4617720" imgH="30268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34334" y="3207036"/>
                        <a:ext cx="3396469" cy="2226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A950E49-E63D-1C3A-8B5A-EBA5AFD854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1053068"/>
              </p:ext>
            </p:extLst>
          </p:nvPr>
        </p:nvGraphicFramePr>
        <p:xfrm>
          <a:off x="1052389" y="1669308"/>
          <a:ext cx="2403825" cy="1814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8" imgW="3511080" imgH="2651760" progId="Prism5.Document">
                  <p:embed/>
                </p:oleObj>
              </mc:Choice>
              <mc:Fallback>
                <p:oleObj name="Prism 5" r:id="rId8" imgW="3511080" imgH="26517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052389" y="1669308"/>
                        <a:ext cx="2403825" cy="1814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280898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CE1523DE-568F-91DA-323E-E0046106A930}"/>
              </a:ext>
            </a:extLst>
          </p:cNvPr>
          <p:cNvSpPr txBox="1"/>
          <p:nvPr/>
        </p:nvSpPr>
        <p:spPr>
          <a:xfrm>
            <a:off x="291491" y="3665597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3153301-8330-4816-A7D9-EB001828D1A0}"/>
              </a:ext>
            </a:extLst>
          </p:cNvPr>
          <p:cNvSpPr txBox="1"/>
          <p:nvPr/>
        </p:nvSpPr>
        <p:spPr>
          <a:xfrm>
            <a:off x="2667977" y="454139"/>
            <a:ext cx="39528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ary </a:t>
            </a:r>
            <a:r>
              <a:rPr lang="en-US" sz="1800" b="1"/>
              <a:t>Figure S2. </a:t>
            </a:r>
            <a:endParaRPr lang="en-US" dirty="0"/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33531A2F-A51A-E395-2ECD-51C33FABC8B3}"/>
              </a:ext>
            </a:extLst>
          </p:cNvPr>
          <p:cNvGrpSpPr/>
          <p:nvPr/>
        </p:nvGrpSpPr>
        <p:grpSpPr>
          <a:xfrm>
            <a:off x="378931" y="3771798"/>
            <a:ext cx="3539835" cy="2619203"/>
            <a:chOff x="7433557" y="4106630"/>
            <a:chExt cx="4738937" cy="2985778"/>
          </a:xfrm>
        </p:grpSpPr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C1A68D12-5068-4770-BD63-576837101CC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04335041"/>
                </p:ext>
              </p:extLst>
            </p:nvPr>
          </p:nvGraphicFramePr>
          <p:xfrm>
            <a:off x="7433557" y="4106630"/>
            <a:ext cx="4738937" cy="29857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2" name="TextBox 42">
              <a:extLst>
                <a:ext uri="{FF2B5EF4-FFF2-40B4-BE49-F238E27FC236}">
                  <a16:creationId xmlns:a16="http://schemas.microsoft.com/office/drawing/2014/main" id="{F87AB9AF-1392-DF0D-847E-49EE51D49C05}"/>
                </a:ext>
              </a:extLst>
            </p:cNvPr>
            <p:cNvSpPr txBox="1"/>
            <p:nvPr/>
          </p:nvSpPr>
          <p:spPr>
            <a:xfrm>
              <a:off x="8302569" y="4972247"/>
              <a:ext cx="377025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  <p:sp>
          <p:nvSpPr>
            <p:cNvPr id="13" name="TextBox 42">
              <a:extLst>
                <a:ext uri="{FF2B5EF4-FFF2-40B4-BE49-F238E27FC236}">
                  <a16:creationId xmlns:a16="http://schemas.microsoft.com/office/drawing/2014/main" id="{4096334A-4F06-8C71-4A82-186A73D6B27D}"/>
                </a:ext>
              </a:extLst>
            </p:cNvPr>
            <p:cNvSpPr txBox="1"/>
            <p:nvPr/>
          </p:nvSpPr>
          <p:spPr>
            <a:xfrm>
              <a:off x="8162033" y="6005981"/>
              <a:ext cx="312907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</a:t>
              </a:r>
            </a:p>
          </p:txBody>
        </p:sp>
        <p:sp>
          <p:nvSpPr>
            <p:cNvPr id="14" name="TextBox 42">
              <a:extLst>
                <a:ext uri="{FF2B5EF4-FFF2-40B4-BE49-F238E27FC236}">
                  <a16:creationId xmlns:a16="http://schemas.microsoft.com/office/drawing/2014/main" id="{CFAD733B-2100-9088-8869-DCB4B72CD4BE}"/>
                </a:ext>
              </a:extLst>
            </p:cNvPr>
            <p:cNvSpPr txBox="1"/>
            <p:nvPr/>
          </p:nvSpPr>
          <p:spPr>
            <a:xfrm>
              <a:off x="8575396" y="5378914"/>
              <a:ext cx="248787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</a:t>
              </a:r>
            </a:p>
          </p:txBody>
        </p:sp>
        <p:sp>
          <p:nvSpPr>
            <p:cNvPr id="15" name="TextBox 42">
              <a:extLst>
                <a:ext uri="{FF2B5EF4-FFF2-40B4-BE49-F238E27FC236}">
                  <a16:creationId xmlns:a16="http://schemas.microsoft.com/office/drawing/2014/main" id="{294255B2-564E-2F12-8CEC-FFEE781412AB}"/>
                </a:ext>
              </a:extLst>
            </p:cNvPr>
            <p:cNvSpPr txBox="1"/>
            <p:nvPr/>
          </p:nvSpPr>
          <p:spPr>
            <a:xfrm>
              <a:off x="9282275" y="4585883"/>
              <a:ext cx="377025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  <p:sp>
          <p:nvSpPr>
            <p:cNvPr id="16" name="TextBox 42">
              <a:extLst>
                <a:ext uri="{FF2B5EF4-FFF2-40B4-BE49-F238E27FC236}">
                  <a16:creationId xmlns:a16="http://schemas.microsoft.com/office/drawing/2014/main" id="{26D99268-8BEA-0AC9-31CD-13A9EA9B2736}"/>
                </a:ext>
              </a:extLst>
            </p:cNvPr>
            <p:cNvSpPr txBox="1"/>
            <p:nvPr/>
          </p:nvSpPr>
          <p:spPr>
            <a:xfrm>
              <a:off x="9505299" y="5131356"/>
              <a:ext cx="312907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</a:t>
              </a:r>
            </a:p>
          </p:txBody>
        </p:sp>
        <p:sp>
          <p:nvSpPr>
            <p:cNvPr id="17" name="TextBox 42">
              <a:extLst>
                <a:ext uri="{FF2B5EF4-FFF2-40B4-BE49-F238E27FC236}">
                  <a16:creationId xmlns:a16="http://schemas.microsoft.com/office/drawing/2014/main" id="{6950A282-B4E9-EB5B-8834-4A0CB3E8813E}"/>
                </a:ext>
              </a:extLst>
            </p:cNvPr>
            <p:cNvSpPr txBox="1"/>
            <p:nvPr/>
          </p:nvSpPr>
          <p:spPr>
            <a:xfrm>
              <a:off x="9092638" y="6064025"/>
              <a:ext cx="377025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  <p:sp>
          <p:nvSpPr>
            <p:cNvPr id="18" name="TextBox 42">
              <a:extLst>
                <a:ext uri="{FF2B5EF4-FFF2-40B4-BE49-F238E27FC236}">
                  <a16:creationId xmlns:a16="http://schemas.microsoft.com/office/drawing/2014/main" id="{645CB101-2CBB-246D-766A-24E49FCD09A3}"/>
                </a:ext>
              </a:extLst>
            </p:cNvPr>
            <p:cNvSpPr txBox="1"/>
            <p:nvPr/>
          </p:nvSpPr>
          <p:spPr>
            <a:xfrm>
              <a:off x="10254692" y="4564628"/>
              <a:ext cx="377025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  <p:sp>
          <p:nvSpPr>
            <p:cNvPr id="19" name="TextBox 42">
              <a:extLst>
                <a:ext uri="{FF2B5EF4-FFF2-40B4-BE49-F238E27FC236}">
                  <a16:creationId xmlns:a16="http://schemas.microsoft.com/office/drawing/2014/main" id="{3025A99C-BB23-DB5B-8513-D1220C87AE40}"/>
                </a:ext>
              </a:extLst>
            </p:cNvPr>
            <p:cNvSpPr txBox="1"/>
            <p:nvPr/>
          </p:nvSpPr>
          <p:spPr>
            <a:xfrm>
              <a:off x="10526200" y="5377578"/>
              <a:ext cx="248787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</a:t>
              </a:r>
            </a:p>
          </p:txBody>
        </p:sp>
        <p:sp>
          <p:nvSpPr>
            <p:cNvPr id="20" name="TextBox 42">
              <a:extLst>
                <a:ext uri="{FF2B5EF4-FFF2-40B4-BE49-F238E27FC236}">
                  <a16:creationId xmlns:a16="http://schemas.microsoft.com/office/drawing/2014/main" id="{3A7E8D5F-CD0C-2308-C55E-316ED8584789}"/>
                </a:ext>
              </a:extLst>
            </p:cNvPr>
            <p:cNvSpPr txBox="1"/>
            <p:nvPr/>
          </p:nvSpPr>
          <p:spPr>
            <a:xfrm>
              <a:off x="10072344" y="6055560"/>
              <a:ext cx="377025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4A893E1C-7E81-74EC-412E-279B97DC7586}"/>
              </a:ext>
            </a:extLst>
          </p:cNvPr>
          <p:cNvGrpSpPr/>
          <p:nvPr/>
        </p:nvGrpSpPr>
        <p:grpSpPr>
          <a:xfrm>
            <a:off x="3771825" y="3741829"/>
            <a:ext cx="3749288" cy="2679142"/>
            <a:chOff x="213857" y="4944528"/>
            <a:chExt cx="3824679" cy="2679142"/>
          </a:xfrm>
        </p:grpSpPr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EEA61AD1-E2F7-4561-93D5-87F0F94778E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36159331"/>
                </p:ext>
              </p:extLst>
            </p:nvPr>
          </p:nvGraphicFramePr>
          <p:xfrm>
            <a:off x="213857" y="4944528"/>
            <a:ext cx="3824679" cy="2679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1" name="TextBox 42">
              <a:extLst>
                <a:ext uri="{FF2B5EF4-FFF2-40B4-BE49-F238E27FC236}">
                  <a16:creationId xmlns:a16="http://schemas.microsoft.com/office/drawing/2014/main" id="{C27C4BEC-7F01-5C96-1FDC-8FDB3E90DFFB}"/>
                </a:ext>
              </a:extLst>
            </p:cNvPr>
            <p:cNvSpPr txBox="1"/>
            <p:nvPr/>
          </p:nvSpPr>
          <p:spPr>
            <a:xfrm>
              <a:off x="1018897" y="5851968"/>
              <a:ext cx="199670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</a:t>
              </a:r>
            </a:p>
          </p:txBody>
        </p:sp>
        <p:sp>
          <p:nvSpPr>
            <p:cNvPr id="22" name="TextBox 42">
              <a:extLst>
                <a:ext uri="{FF2B5EF4-FFF2-40B4-BE49-F238E27FC236}">
                  <a16:creationId xmlns:a16="http://schemas.microsoft.com/office/drawing/2014/main" id="{562957AF-4834-4175-8AFE-00A474AD5BEA}"/>
                </a:ext>
              </a:extLst>
            </p:cNvPr>
            <p:cNvSpPr txBox="1"/>
            <p:nvPr/>
          </p:nvSpPr>
          <p:spPr>
            <a:xfrm>
              <a:off x="822512" y="6428767"/>
              <a:ext cx="251131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</a:t>
              </a:r>
            </a:p>
          </p:txBody>
        </p:sp>
        <p:sp>
          <p:nvSpPr>
            <p:cNvPr id="24" name="TextBox 42">
              <a:extLst>
                <a:ext uri="{FF2B5EF4-FFF2-40B4-BE49-F238E27FC236}">
                  <a16:creationId xmlns:a16="http://schemas.microsoft.com/office/drawing/2014/main" id="{B6FCB9DA-BD89-1C7D-00A9-CDA591D6843A}"/>
                </a:ext>
              </a:extLst>
            </p:cNvPr>
            <p:cNvSpPr txBox="1"/>
            <p:nvPr/>
          </p:nvSpPr>
          <p:spPr>
            <a:xfrm>
              <a:off x="1179893" y="5783193"/>
              <a:ext cx="199670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</a:t>
              </a:r>
            </a:p>
          </p:txBody>
        </p:sp>
        <p:sp>
          <p:nvSpPr>
            <p:cNvPr id="25" name="TextBox 42">
              <a:extLst>
                <a:ext uri="{FF2B5EF4-FFF2-40B4-BE49-F238E27FC236}">
                  <a16:creationId xmlns:a16="http://schemas.microsoft.com/office/drawing/2014/main" id="{89A524F1-D05F-BCD7-698C-0B363801188D}"/>
                </a:ext>
              </a:extLst>
            </p:cNvPr>
            <p:cNvSpPr txBox="1"/>
            <p:nvPr/>
          </p:nvSpPr>
          <p:spPr>
            <a:xfrm>
              <a:off x="1802857" y="5371552"/>
              <a:ext cx="302592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  <p:sp>
          <p:nvSpPr>
            <p:cNvPr id="26" name="TextBox 42">
              <a:extLst>
                <a:ext uri="{FF2B5EF4-FFF2-40B4-BE49-F238E27FC236}">
                  <a16:creationId xmlns:a16="http://schemas.microsoft.com/office/drawing/2014/main" id="{DDC29172-1CA2-7EBF-EA47-8F0B4199741B}"/>
                </a:ext>
              </a:extLst>
            </p:cNvPr>
            <p:cNvSpPr txBox="1"/>
            <p:nvPr/>
          </p:nvSpPr>
          <p:spPr>
            <a:xfrm>
              <a:off x="2001786" y="5680967"/>
              <a:ext cx="251131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</a:t>
              </a:r>
            </a:p>
          </p:txBody>
        </p:sp>
        <p:sp>
          <p:nvSpPr>
            <p:cNvPr id="27" name="TextBox 42">
              <a:extLst>
                <a:ext uri="{FF2B5EF4-FFF2-40B4-BE49-F238E27FC236}">
                  <a16:creationId xmlns:a16="http://schemas.microsoft.com/office/drawing/2014/main" id="{AD0E642A-1816-C957-0A42-444F30F4168A}"/>
                </a:ext>
              </a:extLst>
            </p:cNvPr>
            <p:cNvSpPr txBox="1"/>
            <p:nvPr/>
          </p:nvSpPr>
          <p:spPr>
            <a:xfrm>
              <a:off x="1678740" y="6498185"/>
              <a:ext cx="302592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  <p:sp>
          <p:nvSpPr>
            <p:cNvPr id="28" name="TextBox 42">
              <a:extLst>
                <a:ext uri="{FF2B5EF4-FFF2-40B4-BE49-F238E27FC236}">
                  <a16:creationId xmlns:a16="http://schemas.microsoft.com/office/drawing/2014/main" id="{ADE6583F-D615-D824-D7DE-B3CAD344556C}"/>
                </a:ext>
              </a:extLst>
            </p:cNvPr>
            <p:cNvSpPr txBox="1"/>
            <p:nvPr/>
          </p:nvSpPr>
          <p:spPr>
            <a:xfrm>
              <a:off x="2682752" y="5765977"/>
              <a:ext cx="251131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</a:t>
              </a:r>
            </a:p>
          </p:txBody>
        </p:sp>
        <p:sp>
          <p:nvSpPr>
            <p:cNvPr id="30" name="TextBox 42">
              <a:extLst>
                <a:ext uri="{FF2B5EF4-FFF2-40B4-BE49-F238E27FC236}">
                  <a16:creationId xmlns:a16="http://schemas.microsoft.com/office/drawing/2014/main" id="{2CCFCB46-7588-C01D-F484-CA5E57FE1FE3}"/>
                </a:ext>
              </a:extLst>
            </p:cNvPr>
            <p:cNvSpPr txBox="1"/>
            <p:nvPr/>
          </p:nvSpPr>
          <p:spPr>
            <a:xfrm>
              <a:off x="2888386" y="5753373"/>
              <a:ext cx="199670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</a:t>
              </a:r>
            </a:p>
          </p:txBody>
        </p:sp>
        <p:sp>
          <p:nvSpPr>
            <p:cNvPr id="34" name="TextBox 42">
              <a:extLst>
                <a:ext uri="{FF2B5EF4-FFF2-40B4-BE49-F238E27FC236}">
                  <a16:creationId xmlns:a16="http://schemas.microsoft.com/office/drawing/2014/main" id="{A9B9F8F4-1DE9-552C-1553-8E8578C155DD}"/>
                </a:ext>
              </a:extLst>
            </p:cNvPr>
            <p:cNvSpPr txBox="1"/>
            <p:nvPr/>
          </p:nvSpPr>
          <p:spPr>
            <a:xfrm>
              <a:off x="2499140" y="6444210"/>
              <a:ext cx="302592" cy="215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180C07A3-3BD0-0BBC-8731-E5D61BFA65F1}"/>
              </a:ext>
            </a:extLst>
          </p:cNvPr>
          <p:cNvGrpSpPr/>
          <p:nvPr/>
        </p:nvGrpSpPr>
        <p:grpSpPr>
          <a:xfrm>
            <a:off x="481607" y="6344778"/>
            <a:ext cx="3749288" cy="2680651"/>
            <a:chOff x="-5567296" y="1516179"/>
            <a:chExt cx="5007463" cy="3037010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1D1F8371-7506-40D5-8D60-D47693BD0A2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95952167"/>
                </p:ext>
              </p:extLst>
            </p:nvPr>
          </p:nvGraphicFramePr>
          <p:xfrm>
            <a:off x="-5567296" y="1516179"/>
            <a:ext cx="5007463" cy="30370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7" name="TextBox 42">
              <a:extLst>
                <a:ext uri="{FF2B5EF4-FFF2-40B4-BE49-F238E27FC236}">
                  <a16:creationId xmlns:a16="http://schemas.microsoft.com/office/drawing/2014/main" id="{373082BD-D2FE-923E-B902-D06915262D5E}"/>
                </a:ext>
              </a:extLst>
            </p:cNvPr>
            <p:cNvSpPr txBox="1"/>
            <p:nvPr/>
          </p:nvSpPr>
          <p:spPr>
            <a:xfrm>
              <a:off x="-4571675" y="2739926"/>
              <a:ext cx="312907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</a:t>
              </a:r>
            </a:p>
          </p:txBody>
        </p:sp>
        <p:sp>
          <p:nvSpPr>
            <p:cNvPr id="38" name="TextBox 42">
              <a:extLst>
                <a:ext uri="{FF2B5EF4-FFF2-40B4-BE49-F238E27FC236}">
                  <a16:creationId xmlns:a16="http://schemas.microsoft.com/office/drawing/2014/main" id="{0239B8C5-ECD9-C02D-9F3D-4A140C9F9F6B}"/>
                </a:ext>
              </a:extLst>
            </p:cNvPr>
            <p:cNvSpPr txBox="1"/>
            <p:nvPr/>
          </p:nvSpPr>
          <p:spPr>
            <a:xfrm>
              <a:off x="-4811538" y="3150013"/>
              <a:ext cx="377025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  <p:sp>
          <p:nvSpPr>
            <p:cNvPr id="39" name="TextBox 42">
              <a:extLst>
                <a:ext uri="{FF2B5EF4-FFF2-40B4-BE49-F238E27FC236}">
                  <a16:creationId xmlns:a16="http://schemas.microsoft.com/office/drawing/2014/main" id="{4E249449-5D2F-AA9F-ECEA-6105279818B5}"/>
                </a:ext>
              </a:extLst>
            </p:cNvPr>
            <p:cNvSpPr txBox="1"/>
            <p:nvPr/>
          </p:nvSpPr>
          <p:spPr>
            <a:xfrm>
              <a:off x="-4309362" y="2574438"/>
              <a:ext cx="2487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</a:t>
              </a:r>
            </a:p>
          </p:txBody>
        </p:sp>
        <p:sp>
          <p:nvSpPr>
            <p:cNvPr id="40" name="TextBox 42">
              <a:extLst>
                <a:ext uri="{FF2B5EF4-FFF2-40B4-BE49-F238E27FC236}">
                  <a16:creationId xmlns:a16="http://schemas.microsoft.com/office/drawing/2014/main" id="{2E182DEE-C8A1-D74A-847B-D997BD2DDE19}"/>
                </a:ext>
              </a:extLst>
            </p:cNvPr>
            <p:cNvSpPr txBox="1"/>
            <p:nvPr/>
          </p:nvSpPr>
          <p:spPr>
            <a:xfrm>
              <a:off x="-3437081" y="2123302"/>
              <a:ext cx="30489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ns</a:t>
              </a:r>
            </a:p>
          </p:txBody>
        </p:sp>
        <p:sp>
          <p:nvSpPr>
            <p:cNvPr id="41" name="TextBox 42">
              <a:extLst>
                <a:ext uri="{FF2B5EF4-FFF2-40B4-BE49-F238E27FC236}">
                  <a16:creationId xmlns:a16="http://schemas.microsoft.com/office/drawing/2014/main" id="{502A1D62-DF17-CDD1-4646-CA3671D75627}"/>
                </a:ext>
              </a:extLst>
            </p:cNvPr>
            <p:cNvSpPr txBox="1"/>
            <p:nvPr/>
          </p:nvSpPr>
          <p:spPr>
            <a:xfrm>
              <a:off x="-3227771" y="2014291"/>
              <a:ext cx="30489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ns</a:t>
              </a:r>
            </a:p>
          </p:txBody>
        </p:sp>
        <p:sp>
          <p:nvSpPr>
            <p:cNvPr id="42" name="TextBox 42">
              <a:extLst>
                <a:ext uri="{FF2B5EF4-FFF2-40B4-BE49-F238E27FC236}">
                  <a16:creationId xmlns:a16="http://schemas.microsoft.com/office/drawing/2014/main" id="{9A8CDBCB-E344-A445-6614-39CBBC36C2B7}"/>
                </a:ext>
              </a:extLst>
            </p:cNvPr>
            <p:cNvSpPr txBox="1"/>
            <p:nvPr/>
          </p:nvSpPr>
          <p:spPr>
            <a:xfrm>
              <a:off x="-3697597" y="3062925"/>
              <a:ext cx="377025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F0489A2-C640-C327-46A3-3AD8A22FBC31}"/>
                </a:ext>
              </a:extLst>
            </p:cNvPr>
            <p:cNvSpPr txBox="1"/>
            <p:nvPr/>
          </p:nvSpPr>
          <p:spPr>
            <a:xfrm>
              <a:off x="-2135889" y="2090760"/>
              <a:ext cx="30489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ns</a:t>
              </a:r>
            </a:p>
          </p:txBody>
        </p:sp>
        <p:sp>
          <p:nvSpPr>
            <p:cNvPr id="44" name="TextBox 42">
              <a:extLst>
                <a:ext uri="{FF2B5EF4-FFF2-40B4-BE49-F238E27FC236}">
                  <a16:creationId xmlns:a16="http://schemas.microsoft.com/office/drawing/2014/main" id="{9E059504-B288-1350-DF1E-616186FD8315}"/>
                </a:ext>
              </a:extLst>
            </p:cNvPr>
            <p:cNvSpPr txBox="1"/>
            <p:nvPr/>
          </p:nvSpPr>
          <p:spPr>
            <a:xfrm>
              <a:off x="-2298862" y="2454479"/>
              <a:ext cx="2487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</a:t>
              </a:r>
            </a:p>
          </p:txBody>
        </p:sp>
        <p:sp>
          <p:nvSpPr>
            <p:cNvPr id="45" name="TextBox 42">
              <a:extLst>
                <a:ext uri="{FF2B5EF4-FFF2-40B4-BE49-F238E27FC236}">
                  <a16:creationId xmlns:a16="http://schemas.microsoft.com/office/drawing/2014/main" id="{01E8057D-F4BE-D39B-F3E4-A907D25A65BC}"/>
                </a:ext>
              </a:extLst>
            </p:cNvPr>
            <p:cNvSpPr txBox="1"/>
            <p:nvPr/>
          </p:nvSpPr>
          <p:spPr>
            <a:xfrm>
              <a:off x="-2528916" y="3066029"/>
              <a:ext cx="37702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***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B8379C0B-15EF-EBF0-A178-96F11229CC94}"/>
              </a:ext>
            </a:extLst>
          </p:cNvPr>
          <p:cNvSpPr txBox="1"/>
          <p:nvPr/>
        </p:nvSpPr>
        <p:spPr>
          <a:xfrm>
            <a:off x="549867" y="1218983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A</a:t>
            </a:r>
          </a:p>
        </p:txBody>
      </p:sp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0F0288FB-93AD-589D-4825-889648C769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7083276"/>
              </p:ext>
            </p:extLst>
          </p:nvPr>
        </p:nvGraphicFramePr>
        <p:xfrm>
          <a:off x="324254" y="1335177"/>
          <a:ext cx="3671868" cy="2346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5" imgW="4565880" imgH="2917080" progId="Prism5.Document">
                  <p:embed/>
                </p:oleObj>
              </mc:Choice>
              <mc:Fallback>
                <p:oleObj name="Prism 5" r:id="rId5" imgW="4565880" imgH="29170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4254" y="1335177"/>
                        <a:ext cx="3671868" cy="2346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FC09F28-161D-F555-230A-F82A3E4A46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8139696"/>
              </p:ext>
            </p:extLst>
          </p:nvPr>
        </p:nvGraphicFramePr>
        <p:xfrm>
          <a:off x="3841598" y="1238957"/>
          <a:ext cx="3366746" cy="2346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7" imgW="4657320" imgH="3246120" progId="Prism5.Document">
                  <p:embed/>
                </p:oleObj>
              </mc:Choice>
              <mc:Fallback>
                <p:oleObj name="Prism 5" r:id="rId7" imgW="4657320" imgH="32461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41598" y="1238957"/>
                        <a:ext cx="3366746" cy="2346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806915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BD1D9133-EB01-2DD8-90B0-DAC2EC8A8576}"/>
              </a:ext>
            </a:extLst>
          </p:cNvPr>
          <p:cNvSpPr txBox="1"/>
          <p:nvPr/>
        </p:nvSpPr>
        <p:spPr>
          <a:xfrm>
            <a:off x="2366731" y="138381"/>
            <a:ext cx="35623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ary Figure S3 </a:t>
            </a:r>
            <a:endParaRPr lang="en-US" dirty="0"/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FD197ED4-655D-05D7-33FA-D741AF4F05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2942009"/>
              </p:ext>
            </p:extLst>
          </p:nvPr>
        </p:nvGraphicFramePr>
        <p:xfrm>
          <a:off x="4557665" y="1568192"/>
          <a:ext cx="3177736" cy="22826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8704">
                  <a:extLst>
                    <a:ext uri="{9D8B030D-6E8A-4147-A177-3AD203B41FA5}">
                      <a16:colId xmlns:a16="http://schemas.microsoft.com/office/drawing/2014/main" val="4069869957"/>
                    </a:ext>
                  </a:extLst>
                </a:gridCol>
                <a:gridCol w="842962">
                  <a:extLst>
                    <a:ext uri="{9D8B030D-6E8A-4147-A177-3AD203B41FA5}">
                      <a16:colId xmlns:a16="http://schemas.microsoft.com/office/drawing/2014/main" val="3487777337"/>
                    </a:ext>
                  </a:extLst>
                </a:gridCol>
                <a:gridCol w="442913">
                  <a:extLst>
                    <a:ext uri="{9D8B030D-6E8A-4147-A177-3AD203B41FA5}">
                      <a16:colId xmlns:a16="http://schemas.microsoft.com/office/drawing/2014/main" val="3706039256"/>
                    </a:ext>
                  </a:extLst>
                </a:gridCol>
                <a:gridCol w="577610">
                  <a:extLst>
                    <a:ext uri="{9D8B030D-6E8A-4147-A177-3AD203B41FA5}">
                      <a16:colId xmlns:a16="http://schemas.microsoft.com/office/drawing/2014/main" val="2141712801"/>
                    </a:ext>
                  </a:extLst>
                </a:gridCol>
                <a:gridCol w="635547">
                  <a:extLst>
                    <a:ext uri="{9D8B030D-6E8A-4147-A177-3AD203B41FA5}">
                      <a16:colId xmlns:a16="http://schemas.microsoft.com/office/drawing/2014/main" val="43500726"/>
                    </a:ext>
                  </a:extLst>
                </a:gridCol>
              </a:tblGrid>
              <a:tr h="3958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SE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Cell Li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  <a:latin typeface="+mn-lt"/>
                        </a:rPr>
                        <a:t>Grad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IC50 (µM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S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3914761"/>
                  </a:ext>
                </a:extLst>
              </a:tr>
              <a:tr h="202761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E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D-54 M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+mn-lt"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66.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0.0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8523421"/>
                  </a:ext>
                </a:extLst>
              </a:tr>
              <a:tr h="3958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U-251 M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>
                          <a:effectLst/>
                          <a:latin typeface="+mn-lt"/>
                        </a:rPr>
                        <a:t>54.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0.0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5567346"/>
                  </a:ext>
                </a:extLst>
              </a:tr>
              <a:tr h="20276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U-8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+mn-lt"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77.8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0.0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2428714"/>
                  </a:ext>
                </a:extLst>
              </a:tr>
              <a:tr h="202761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+mn-lt"/>
                        </a:rPr>
                        <a:t>NML</a:t>
                      </a:r>
                    </a:p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+mn-lt"/>
                        </a:rPr>
                        <a:t>MCF10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226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0.00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9823373"/>
                  </a:ext>
                </a:extLst>
              </a:tr>
              <a:tr h="20276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HPF24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228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0.0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8118351"/>
                  </a:ext>
                </a:extLst>
              </a:tr>
              <a:tr h="20276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98G</a:t>
                      </a: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88.5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0.04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9154253"/>
                  </a:ext>
                </a:extLst>
              </a:tr>
              <a:tr h="20276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Human Astrocyt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17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0.02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1299574"/>
                  </a:ext>
                </a:extLst>
              </a:tr>
              <a:tr h="202761">
                <a:tc>
                  <a:txBody>
                    <a:bodyPr/>
                    <a:lstStyle/>
                    <a:p>
                      <a:r>
                        <a:rPr lang="en-US" sz="12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D-PED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CHLA-2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 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85.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u="none" strike="noStrike" dirty="0">
                          <a:effectLst/>
                          <a:latin typeface="+mn-lt"/>
                        </a:rPr>
                        <a:t>0.0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>
                    <a:solidFill>
                      <a:schemeClr val="tx2">
                        <a:lumMod val="20000"/>
                        <a:lumOff val="80000"/>
                        <a:alpha val="32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1052577"/>
                  </a:ext>
                </a:extLst>
              </a:tr>
            </a:tbl>
          </a:graphicData>
        </a:graphic>
      </p:graphicFrame>
      <p:graphicFrame>
        <p:nvGraphicFramePr>
          <p:cNvPr id="23" name="Content Placeholder 4">
            <a:extLst>
              <a:ext uri="{FF2B5EF4-FFF2-40B4-BE49-F238E27FC236}">
                <a16:creationId xmlns:a16="http://schemas.microsoft.com/office/drawing/2014/main" id="{E56622AE-7731-3FA1-2828-1432D6415E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946242"/>
              </p:ext>
            </p:extLst>
          </p:nvPr>
        </p:nvGraphicFramePr>
        <p:xfrm>
          <a:off x="792900" y="4849881"/>
          <a:ext cx="2993843" cy="185737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909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0095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0095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0095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23642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solidFill>
                            <a:schemeClr val="tx1"/>
                          </a:solidFill>
                          <a:latin typeface="+mn-lt"/>
                        </a:rPr>
                        <a:t>IC</a:t>
                      </a:r>
                      <a:r>
                        <a:rPr lang="en-US" sz="1200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5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+mn-lt"/>
                        </a:rPr>
                        <a:t>values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1962176"/>
                  </a:ext>
                </a:extLst>
              </a:tr>
              <a:tr h="372737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+mn-lt"/>
                        </a:rPr>
                        <a:t>Cell Lines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+mn-lt"/>
                        </a:rPr>
                        <a:t>BT#395 </a:t>
                      </a:r>
                    </a:p>
                    <a:p>
                      <a:pPr algn="ctr"/>
                      <a:r>
                        <a:rPr lang="en-US" sz="1200" b="1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µM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+mn-lt"/>
                        </a:rPr>
                        <a:t>BT#397</a:t>
                      </a:r>
                    </a:p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µM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+mn-lt"/>
                        </a:rPr>
                        <a:t>BT#399 </a:t>
                      </a:r>
                      <a:r>
                        <a:rPr lang="en-US" sz="1200" b="1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µM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3642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D54-MG</a:t>
                      </a:r>
                      <a:endParaRPr lang="en-US" sz="1200" dirty="0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.46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.98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.572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3642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U251</a:t>
                      </a:r>
                      <a:endParaRPr lang="en-US" sz="1200" dirty="0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8.25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7.65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.37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5224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U87</a:t>
                      </a:r>
                      <a:endParaRPr lang="en-US" sz="1200" dirty="0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~23.7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~209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4.7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3604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HPF242</a:t>
                      </a:r>
                      <a:endParaRPr lang="en-US" sz="1200" dirty="0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.98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5.9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~ 3.33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5224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MCF10A</a:t>
                      </a:r>
                      <a:endParaRPr lang="en-US" sz="1200" dirty="0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5.0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~22.8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~9.30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584CB65D-B0AB-8228-1283-F104CA0563DD}"/>
              </a:ext>
            </a:extLst>
          </p:cNvPr>
          <p:cNvSpPr txBox="1"/>
          <p:nvPr/>
        </p:nvSpPr>
        <p:spPr>
          <a:xfrm>
            <a:off x="260486" y="1386931"/>
            <a:ext cx="4865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951FDEF-0174-9457-2278-D2A590BB9220}"/>
              </a:ext>
            </a:extLst>
          </p:cNvPr>
          <p:cNvSpPr txBox="1"/>
          <p:nvPr/>
        </p:nvSpPr>
        <p:spPr>
          <a:xfrm>
            <a:off x="260486" y="4713867"/>
            <a:ext cx="4865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B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DEE6A13-A8D9-C43E-EE3C-D86CCE72D0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8541728"/>
              </p:ext>
            </p:extLst>
          </p:nvPr>
        </p:nvGraphicFramePr>
        <p:xfrm>
          <a:off x="260486" y="1682999"/>
          <a:ext cx="4324905" cy="2389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5792760" imgH="3200400" progId="Prism5.Document">
                  <p:embed/>
                </p:oleObj>
              </mc:Choice>
              <mc:Fallback>
                <p:oleObj name="Prism 5" r:id="rId2" imgW="5792760" imgH="3200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0486" y="1682999"/>
                        <a:ext cx="4324905" cy="2389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296990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BD1D9133-EB01-2DD8-90B0-DAC2EC8A8576}"/>
              </a:ext>
            </a:extLst>
          </p:cNvPr>
          <p:cNvSpPr txBox="1"/>
          <p:nvPr/>
        </p:nvSpPr>
        <p:spPr>
          <a:xfrm>
            <a:off x="2366731" y="138381"/>
            <a:ext cx="35623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ary Figure S4 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FA58793-A1F5-18AC-0C2D-1BF296D65E47}"/>
              </a:ext>
            </a:extLst>
          </p:cNvPr>
          <p:cNvSpPr txBox="1"/>
          <p:nvPr/>
        </p:nvSpPr>
        <p:spPr>
          <a:xfrm>
            <a:off x="-32075" y="2777966"/>
            <a:ext cx="317205" cy="3512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B20BFEB-807D-533A-BDE9-637A04FD0F4A}"/>
              </a:ext>
            </a:extLst>
          </p:cNvPr>
          <p:cNvSpPr txBox="1"/>
          <p:nvPr/>
        </p:nvSpPr>
        <p:spPr>
          <a:xfrm>
            <a:off x="-13648" y="6712948"/>
            <a:ext cx="286325" cy="3512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graphicFrame>
        <p:nvGraphicFramePr>
          <p:cNvPr id="63" name="Object 62">
            <a:extLst>
              <a:ext uri="{FF2B5EF4-FFF2-40B4-BE49-F238E27FC236}">
                <a16:creationId xmlns:a16="http://schemas.microsoft.com/office/drawing/2014/main" id="{79BD7D9B-E2B5-B20E-6C01-46D32FF8037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35364" y="2741567"/>
          <a:ext cx="2352484" cy="2139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4014360" imgH="3459600" progId="Prism5.Document">
                  <p:embed/>
                </p:oleObj>
              </mc:Choice>
              <mc:Fallback>
                <p:oleObj name="Prism 5" r:id="rId2" imgW="4014360" imgH="3459600" progId="Prism5.Document">
                  <p:embed/>
                  <p:pic>
                    <p:nvPicPr>
                      <p:cNvPr id="63" name="Object 62">
                        <a:extLst>
                          <a:ext uri="{FF2B5EF4-FFF2-40B4-BE49-F238E27FC236}">
                            <a16:creationId xmlns:a16="http://schemas.microsoft.com/office/drawing/2014/main" id="{79BD7D9B-E2B5-B20E-6C01-46D32FF803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35364" y="2741567"/>
                        <a:ext cx="2352484" cy="2139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2EE1A844-821D-DCBD-197B-7851F8C67E3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363089" y="2671631"/>
          <a:ext cx="2409311" cy="21827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4" imgW="4072320" imgH="3495960" progId="Prism5.Document">
                  <p:embed/>
                </p:oleObj>
              </mc:Choice>
              <mc:Fallback>
                <p:oleObj name="Prism 5" r:id="rId4" imgW="4072320" imgH="3495960" progId="Prism5.Document">
                  <p:embed/>
                  <p:pic>
                    <p:nvPicPr>
                      <p:cNvPr id="64" name="Object 63">
                        <a:extLst>
                          <a:ext uri="{FF2B5EF4-FFF2-40B4-BE49-F238E27FC236}">
                            <a16:creationId xmlns:a16="http://schemas.microsoft.com/office/drawing/2014/main" id="{2EE1A844-821D-DCBD-197B-7851F8C67E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63089" y="2671631"/>
                        <a:ext cx="2409311" cy="21827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37ED610A-DD19-8234-0AA2-D71EDF7BB94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79017" y="4731185"/>
          <a:ext cx="2578316" cy="21541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6" imgW="4062960" imgH="3441240" progId="Prism5.Document">
                  <p:embed/>
                </p:oleObj>
              </mc:Choice>
              <mc:Fallback>
                <p:oleObj name="Prism 5" r:id="rId6" imgW="4062960" imgH="3441240" progId="Prism5.Document">
                  <p:embed/>
                  <p:pic>
                    <p:nvPicPr>
                      <p:cNvPr id="65" name="Object 64">
                        <a:extLst>
                          <a:ext uri="{FF2B5EF4-FFF2-40B4-BE49-F238E27FC236}">
                            <a16:creationId xmlns:a16="http://schemas.microsoft.com/office/drawing/2014/main" id="{37ED610A-DD19-8234-0AA2-D71EDF7BB9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79017" y="4731185"/>
                        <a:ext cx="2578316" cy="21541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8" name="Object 67">
            <a:extLst>
              <a:ext uri="{FF2B5EF4-FFF2-40B4-BE49-F238E27FC236}">
                <a16:creationId xmlns:a16="http://schemas.microsoft.com/office/drawing/2014/main" id="{BCE90C5E-5EAD-8DC9-F72F-DE153D74DE7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6386" y="2807106"/>
          <a:ext cx="2330400" cy="20901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8" imgW="4081320" imgH="3468600" progId="Prism5.Document">
                  <p:embed/>
                </p:oleObj>
              </mc:Choice>
              <mc:Fallback>
                <p:oleObj name="Prism 5" r:id="rId8" imgW="4081320" imgH="3468600" progId="Prism5.Document">
                  <p:embed/>
                  <p:pic>
                    <p:nvPicPr>
                      <p:cNvPr id="68" name="Object 67">
                        <a:extLst>
                          <a:ext uri="{FF2B5EF4-FFF2-40B4-BE49-F238E27FC236}">
                            <a16:creationId xmlns:a16="http://schemas.microsoft.com/office/drawing/2014/main" id="{BCE90C5E-5EAD-8DC9-F72F-DE153D74DE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386" y="2807106"/>
                        <a:ext cx="2330400" cy="20901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3">
            <a:extLst>
              <a:ext uri="{FF2B5EF4-FFF2-40B4-BE49-F238E27FC236}">
                <a16:creationId xmlns:a16="http://schemas.microsoft.com/office/drawing/2014/main" id="{8A67C709-C657-5681-34AF-703FA1BB0535}"/>
              </a:ext>
            </a:extLst>
          </p:cNvPr>
          <p:cNvGrpSpPr/>
          <p:nvPr/>
        </p:nvGrpSpPr>
        <p:grpSpPr>
          <a:xfrm>
            <a:off x="55236" y="6739696"/>
            <a:ext cx="7711958" cy="2091281"/>
            <a:chOff x="374129" y="8742431"/>
            <a:chExt cx="8557449" cy="2198879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1D85B37-073A-C3C0-E90B-E7CB5A4F9962}"/>
                </a:ext>
              </a:extLst>
            </p:cNvPr>
            <p:cNvSpPr txBox="1"/>
            <p:nvPr/>
          </p:nvSpPr>
          <p:spPr>
            <a:xfrm>
              <a:off x="4532746" y="8806639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OG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FB16914-2DE8-E61D-D75A-4B23FCD1FC09}"/>
                </a:ext>
              </a:extLst>
            </p:cNvPr>
            <p:cNvSpPr txBox="1"/>
            <p:nvPr/>
          </p:nvSpPr>
          <p:spPr>
            <a:xfrm>
              <a:off x="6085078" y="8742431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DB93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99A269D-A4C7-8292-F7A8-732CE059DA42}"/>
                </a:ext>
              </a:extLst>
            </p:cNvPr>
            <p:cNvSpPr txBox="1"/>
            <p:nvPr/>
          </p:nvSpPr>
          <p:spPr>
            <a:xfrm>
              <a:off x="1224279" y="881085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D54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1C6209B-748A-5AD4-D64D-95A17750706E}"/>
                </a:ext>
              </a:extLst>
            </p:cNvPr>
            <p:cNvSpPr txBox="1"/>
            <p:nvPr/>
          </p:nvSpPr>
          <p:spPr>
            <a:xfrm>
              <a:off x="2895463" y="8810854"/>
              <a:ext cx="4427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U87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8B92D8D-0241-E5E7-A9DA-4D14133D215E}"/>
                </a:ext>
              </a:extLst>
            </p:cNvPr>
            <p:cNvSpPr txBox="1"/>
            <p:nvPr/>
          </p:nvSpPr>
          <p:spPr>
            <a:xfrm rot="16200000">
              <a:off x="54046" y="9748563"/>
              <a:ext cx="903490" cy="263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BT317 (µM)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83ED4786-EE65-360A-6C25-40E028A43ABB}"/>
                </a:ext>
              </a:extLst>
            </p:cNvPr>
            <p:cNvCxnSpPr/>
            <p:nvPr/>
          </p:nvCxnSpPr>
          <p:spPr>
            <a:xfrm flipV="1">
              <a:off x="610538" y="10662363"/>
              <a:ext cx="8321040" cy="684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66607D3-DB16-D9A3-C1D3-AA8EFF521E49}"/>
                </a:ext>
              </a:extLst>
            </p:cNvPr>
            <p:cNvSpPr txBox="1"/>
            <p:nvPr/>
          </p:nvSpPr>
          <p:spPr>
            <a:xfrm>
              <a:off x="4406920" y="10673093"/>
              <a:ext cx="782044" cy="2682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MZ (µM)</a:t>
              </a:r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51CF1584-919F-C492-170F-93779836DE0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14364" y="9048801"/>
              <a:ext cx="1645920" cy="1554480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FE8AB417-EE31-9AB1-5E93-5D28C49EC4B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275021" y="9056437"/>
              <a:ext cx="1645920" cy="1554480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F0DC80B4-3E95-AE16-9671-E411A984219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991588" y="9056437"/>
              <a:ext cx="1645920" cy="1554480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E35DB97A-8D83-1E98-A399-2DEA7DB6ABC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615025" y="8988015"/>
              <a:ext cx="1645920" cy="1554480"/>
            </a:xfrm>
            <a:prstGeom prst="rect">
              <a:avLst/>
            </a:prstGeom>
          </p:spPr>
        </p:pic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2A5C5B44-5C67-2520-9659-485A5B5C907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313558" y="9048801"/>
              <a:ext cx="1493825" cy="1503918"/>
            </a:xfrm>
            <a:prstGeom prst="rect">
              <a:avLst/>
            </a:prstGeom>
          </p:spPr>
        </p:pic>
      </p:grp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9E9C69A-1885-6AF5-FC96-347403E7C8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8547448"/>
              </p:ext>
            </p:extLst>
          </p:nvPr>
        </p:nvGraphicFramePr>
        <p:xfrm>
          <a:off x="378473" y="905604"/>
          <a:ext cx="2399665" cy="19869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15" imgW="3589200" imgH="2816280" progId="Prism5.Document">
                  <p:embed/>
                </p:oleObj>
              </mc:Choice>
              <mc:Fallback>
                <p:oleObj name="Prism 5" r:id="rId15" imgW="3589200" imgH="2816280" progId="Prism5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9E9C69A-1885-6AF5-FC96-347403E7C8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78473" y="905604"/>
                        <a:ext cx="2399665" cy="19869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332A3482-F2A6-EE34-CA2E-E8A448A3722C}"/>
              </a:ext>
            </a:extLst>
          </p:cNvPr>
          <p:cNvSpPr txBox="1"/>
          <p:nvPr/>
        </p:nvSpPr>
        <p:spPr>
          <a:xfrm>
            <a:off x="6768724" y="6803026"/>
            <a:ext cx="474126" cy="263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B81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6C428980-0642-B297-4474-453AA4F9741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715794" y="4760556"/>
          <a:ext cx="2564338" cy="21207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17" imgW="4062960" imgH="3441240" progId="Prism5.Document">
                  <p:embed/>
                </p:oleObj>
              </mc:Choice>
              <mc:Fallback>
                <p:oleObj name="Prism 5" r:id="rId17" imgW="4062960" imgH="3441240" progId="Prism5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6C428980-0642-B297-4474-453AA4F974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15794" y="4760556"/>
                        <a:ext cx="2564338" cy="21207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FB14BF38-ADE8-4308-C775-086A32CE3D6E}"/>
              </a:ext>
            </a:extLst>
          </p:cNvPr>
          <p:cNvSpPr txBox="1"/>
          <p:nvPr/>
        </p:nvSpPr>
        <p:spPr>
          <a:xfrm>
            <a:off x="11128" y="876464"/>
            <a:ext cx="292104" cy="3512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4803594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BD1D9133-EB01-2DD8-90B0-DAC2EC8A8576}"/>
              </a:ext>
            </a:extLst>
          </p:cNvPr>
          <p:cNvSpPr txBox="1"/>
          <p:nvPr/>
        </p:nvSpPr>
        <p:spPr>
          <a:xfrm>
            <a:off x="2366731" y="138381"/>
            <a:ext cx="35623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ary Figure S5 </a:t>
            </a:r>
            <a:endParaRPr lang="en-US" dirty="0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0600C822-8570-3EEF-33B1-17F843B830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4677" y="1319857"/>
            <a:ext cx="2997451" cy="2526183"/>
          </a:xfrm>
          <a:prstGeom prst="rect">
            <a:avLst/>
          </a:prstGeom>
        </p:spPr>
      </p:pic>
      <p:graphicFrame>
        <p:nvGraphicFramePr>
          <p:cNvPr id="70" name="Object 69">
            <a:extLst>
              <a:ext uri="{FF2B5EF4-FFF2-40B4-BE49-F238E27FC236}">
                <a16:creationId xmlns:a16="http://schemas.microsoft.com/office/drawing/2014/main" id="{0685BB53-FBF9-A0BB-0EE4-821BC49B96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7445467"/>
              </p:ext>
            </p:extLst>
          </p:nvPr>
        </p:nvGraphicFramePr>
        <p:xfrm>
          <a:off x="1193674" y="4597794"/>
          <a:ext cx="4740401" cy="2725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3" imgW="7452000" imgH="4204800" progId="Prism5.Document">
                  <p:embed/>
                </p:oleObj>
              </mc:Choice>
              <mc:Fallback>
                <p:oleObj name="Prism 5" r:id="rId3" imgW="7452000" imgH="4204800" progId="Prism5.Document">
                  <p:embed/>
                  <p:pic>
                    <p:nvPicPr>
                      <p:cNvPr id="70" name="Object 69">
                        <a:extLst>
                          <a:ext uri="{FF2B5EF4-FFF2-40B4-BE49-F238E27FC236}">
                            <a16:creationId xmlns:a16="http://schemas.microsoft.com/office/drawing/2014/main" id="{0685BB53-FBF9-A0BB-0EE4-821BC49B96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93674" y="4597794"/>
                        <a:ext cx="4740401" cy="2725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896658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5D32152-8136-1C3C-BC47-411AAD145165}"/>
              </a:ext>
            </a:extLst>
          </p:cNvPr>
          <p:cNvSpPr txBox="1"/>
          <p:nvPr/>
        </p:nvSpPr>
        <p:spPr>
          <a:xfrm>
            <a:off x="2446867" y="-42197"/>
            <a:ext cx="29294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ary Figure S6 </a:t>
            </a:r>
            <a:endParaRPr lang="en-US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302B42E-4C4C-2A22-7317-19D6F7C3A1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5703" y="5219166"/>
            <a:ext cx="4761947" cy="338893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232D5FA2-F491-BCDE-F2E3-9DF99E9C1F0E}"/>
              </a:ext>
            </a:extLst>
          </p:cNvPr>
          <p:cNvSpPr txBox="1"/>
          <p:nvPr/>
        </p:nvSpPr>
        <p:spPr>
          <a:xfrm>
            <a:off x="1199742" y="521916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D252941-2CE7-6ED2-E1C6-1080A633D2E8}"/>
              </a:ext>
            </a:extLst>
          </p:cNvPr>
          <p:cNvSpPr/>
          <p:nvPr/>
        </p:nvSpPr>
        <p:spPr>
          <a:xfrm>
            <a:off x="1222241" y="2153778"/>
            <a:ext cx="308098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5BCC42D5-75AF-8311-834D-F46EBC0399D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776" r="17058" b="51098"/>
          <a:stretch/>
        </p:blipFill>
        <p:spPr>
          <a:xfrm>
            <a:off x="1136207" y="386488"/>
            <a:ext cx="5041443" cy="4767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0004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0862</TotalTime>
  <Words>300</Words>
  <Application>Microsoft Office PowerPoint</Application>
  <PresentationFormat>Custom</PresentationFormat>
  <Paragraphs>189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Douglas</dc:creator>
  <cp:lastModifiedBy>Bota, Daniela</cp:lastModifiedBy>
  <cp:revision>409</cp:revision>
  <cp:lastPrinted>2024-10-16T22:33:31Z</cp:lastPrinted>
  <dcterms:created xsi:type="dcterms:W3CDTF">2021-06-13T05:38:57Z</dcterms:created>
  <dcterms:modified xsi:type="dcterms:W3CDTF">2024-10-16T23:54:38Z</dcterms:modified>
</cp:coreProperties>
</file>